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8" r:id="rId3"/>
    <p:sldId id="260" r:id="rId4"/>
    <p:sldId id="264" r:id="rId5"/>
    <p:sldId id="262" r:id="rId6"/>
    <p:sldId id="257" r:id="rId7"/>
    <p:sldId id="263" r:id="rId8"/>
  </p:sldIdLst>
  <p:sldSz cx="43205400" cy="32404050"/>
  <p:notesSz cx="6858000" cy="9144000"/>
  <p:defaultTextStyle>
    <a:defPPr>
      <a:defRPr lang="en-US"/>
    </a:defPPr>
    <a:lvl1pPr marL="0" algn="l" defTabSz="104995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24978" algn="l" defTabSz="104995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49954" algn="l" defTabSz="104995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74931" algn="l" defTabSz="104995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99910" algn="l" defTabSz="104995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624886" algn="l" defTabSz="104995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149864" algn="l" defTabSz="104995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674841" algn="l" defTabSz="104995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199818" algn="l" defTabSz="104995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6">
          <p15:clr>
            <a:srgbClr val="A4A3A4"/>
          </p15:clr>
        </p15:guide>
        <p15:guide id="2" pos="1360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39CD14C-418A-4282-B912-5F56C6F49A63}" v="266" dt="2019-03-29T13:13:52.6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6010" autoAdjust="0"/>
    <p:restoredTop sz="94660"/>
  </p:normalViewPr>
  <p:slideViewPr>
    <p:cSldViewPr>
      <p:cViewPr>
        <p:scale>
          <a:sx n="25" d="100"/>
          <a:sy n="25" d="100"/>
        </p:scale>
        <p:origin x="-630" y="882"/>
      </p:cViewPr>
      <p:guideLst>
        <p:guide orient="horz" pos="10206"/>
        <p:guide pos="136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microsoft.com/office/2016/11/relationships/changesInfo" Target="changesInfos/changesInfo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der, Matthew" userId="5a922e2c-39ee-4db6-ad0f-3f2e1fe4e1cd" providerId="ADAL" clId="{139CD14C-418A-4282-B912-5F56C6F49A63}"/>
    <pc:docChg chg="undo custSel addSld delSld modSld">
      <pc:chgData name="Elder, Matthew" userId="5a922e2c-39ee-4db6-ad0f-3f2e1fe4e1cd" providerId="ADAL" clId="{139CD14C-418A-4282-B912-5F56C6F49A63}" dt="2019-03-29T13:13:52.699" v="264" actId="2696"/>
      <pc:docMkLst>
        <pc:docMk/>
      </pc:docMkLst>
      <pc:sldChg chg="addSp delSp modSp">
        <pc:chgData name="Elder, Matthew" userId="5a922e2c-39ee-4db6-ad0f-3f2e1fe4e1cd" providerId="ADAL" clId="{139CD14C-418A-4282-B912-5F56C6F49A63}" dt="2019-03-27T11:48:01.481" v="144" actId="164"/>
        <pc:sldMkLst>
          <pc:docMk/>
          <pc:sldMk cId="98384981" sldId="260"/>
        </pc:sldMkLst>
        <pc:spChg chg="mod">
          <ac:chgData name="Elder, Matthew" userId="5a922e2c-39ee-4db6-ad0f-3f2e1fe4e1cd" providerId="ADAL" clId="{139CD14C-418A-4282-B912-5F56C6F49A63}" dt="2019-03-27T11:48:01.481" v="144" actId="164"/>
          <ac:spMkLst>
            <pc:docMk/>
            <pc:sldMk cId="98384981" sldId="260"/>
            <ac:spMk id="31" creationId="{3BFF1DB6-0686-4AF3-8805-71AC9A87A64B}"/>
          </ac:spMkLst>
        </pc:spChg>
        <pc:spChg chg="mod">
          <ac:chgData name="Elder, Matthew" userId="5a922e2c-39ee-4db6-ad0f-3f2e1fe4e1cd" providerId="ADAL" clId="{139CD14C-418A-4282-B912-5F56C6F49A63}" dt="2019-03-27T11:48:01.481" v="144" actId="164"/>
          <ac:spMkLst>
            <pc:docMk/>
            <pc:sldMk cId="98384981" sldId="260"/>
            <ac:spMk id="32" creationId="{6A1907C9-591F-4D2D-8F83-D75DDF246921}"/>
          </ac:spMkLst>
        </pc:spChg>
        <pc:spChg chg="mod">
          <ac:chgData name="Elder, Matthew" userId="5a922e2c-39ee-4db6-ad0f-3f2e1fe4e1cd" providerId="ADAL" clId="{139CD14C-418A-4282-B912-5F56C6F49A63}" dt="2019-03-27T11:48:01.481" v="144" actId="164"/>
          <ac:spMkLst>
            <pc:docMk/>
            <pc:sldMk cId="98384981" sldId="260"/>
            <ac:spMk id="33" creationId="{0CEF9C00-563F-43D2-9B13-49B6C197AABF}"/>
          </ac:spMkLst>
        </pc:spChg>
        <pc:spChg chg="mod">
          <ac:chgData name="Elder, Matthew" userId="5a922e2c-39ee-4db6-ad0f-3f2e1fe4e1cd" providerId="ADAL" clId="{139CD14C-418A-4282-B912-5F56C6F49A63}" dt="2019-03-27T11:48:01.481" v="144" actId="164"/>
          <ac:spMkLst>
            <pc:docMk/>
            <pc:sldMk cId="98384981" sldId="260"/>
            <ac:spMk id="34" creationId="{628C84DA-A60F-4BB6-A6A5-99845C4F512A}"/>
          </ac:spMkLst>
        </pc:spChg>
        <pc:spChg chg="mod">
          <ac:chgData name="Elder, Matthew" userId="5a922e2c-39ee-4db6-ad0f-3f2e1fe4e1cd" providerId="ADAL" clId="{139CD14C-418A-4282-B912-5F56C6F49A63}" dt="2019-03-27T11:48:01.481" v="144" actId="164"/>
          <ac:spMkLst>
            <pc:docMk/>
            <pc:sldMk cId="98384981" sldId="260"/>
            <ac:spMk id="35" creationId="{29C4A3DA-B6AC-4C84-9A69-2E6441E0CDAD}"/>
          </ac:spMkLst>
        </pc:spChg>
        <pc:spChg chg="mod">
          <ac:chgData name="Elder, Matthew" userId="5a922e2c-39ee-4db6-ad0f-3f2e1fe4e1cd" providerId="ADAL" clId="{139CD14C-418A-4282-B912-5F56C6F49A63}" dt="2019-03-27T11:48:01.481" v="144" actId="164"/>
          <ac:spMkLst>
            <pc:docMk/>
            <pc:sldMk cId="98384981" sldId="260"/>
            <ac:spMk id="36" creationId="{89C05798-6610-4A0A-8022-2286B93B9C67}"/>
          </ac:spMkLst>
        </pc:spChg>
        <pc:grpChg chg="add mod">
          <ac:chgData name="Elder, Matthew" userId="5a922e2c-39ee-4db6-ad0f-3f2e1fe4e1cd" providerId="ADAL" clId="{139CD14C-418A-4282-B912-5F56C6F49A63}" dt="2019-03-27T11:48:01.481" v="144" actId="164"/>
          <ac:grpSpMkLst>
            <pc:docMk/>
            <pc:sldMk cId="98384981" sldId="260"/>
            <ac:grpSpMk id="3" creationId="{E861D3E3-DD93-4949-A7E8-CEFF3D17CD01}"/>
          </ac:grpSpMkLst>
        </pc:grpChg>
        <pc:graphicFrameChg chg="add mod">
          <ac:chgData name="Elder, Matthew" userId="5a922e2c-39ee-4db6-ad0f-3f2e1fe4e1cd" providerId="ADAL" clId="{139CD14C-418A-4282-B912-5F56C6F49A63}" dt="2019-03-27T11:48:01.481" v="144" actId="164"/>
          <ac:graphicFrameMkLst>
            <pc:docMk/>
            <pc:sldMk cId="98384981" sldId="260"/>
            <ac:graphicFrameMk id="2" creationId="{44D6D6DB-B26F-451B-B9B1-27C7597E7921}"/>
          </ac:graphicFrameMkLst>
        </pc:graphicFrameChg>
        <pc:graphicFrameChg chg="mod">
          <ac:chgData name="Elder, Matthew" userId="5a922e2c-39ee-4db6-ad0f-3f2e1fe4e1cd" providerId="ADAL" clId="{139CD14C-418A-4282-B912-5F56C6F49A63}" dt="2019-03-27T11:48:01.481" v="144" actId="164"/>
          <ac:graphicFrameMkLst>
            <pc:docMk/>
            <pc:sldMk cId="98384981" sldId="260"/>
            <ac:graphicFrameMk id="7" creationId="{4CB13A46-2E7E-44C2-B748-3F4E4C368D12}"/>
          </ac:graphicFrameMkLst>
        </pc:graphicFrameChg>
        <pc:graphicFrameChg chg="mod">
          <ac:chgData name="Elder, Matthew" userId="5a922e2c-39ee-4db6-ad0f-3f2e1fe4e1cd" providerId="ADAL" clId="{139CD14C-418A-4282-B912-5F56C6F49A63}" dt="2019-03-27T11:48:01.481" v="144" actId="164"/>
          <ac:graphicFrameMkLst>
            <pc:docMk/>
            <pc:sldMk cId="98384981" sldId="260"/>
            <ac:graphicFrameMk id="12" creationId="{5BE6129B-6D0A-48DE-8583-B91522B7FA26}"/>
          </ac:graphicFrameMkLst>
        </pc:graphicFrameChg>
        <pc:graphicFrameChg chg="del mod ord">
          <ac:chgData name="Elder, Matthew" userId="5a922e2c-39ee-4db6-ad0f-3f2e1fe4e1cd" providerId="ADAL" clId="{139CD14C-418A-4282-B912-5F56C6F49A63}" dt="2019-03-27T11:46:32.259" v="2" actId="478"/>
          <ac:graphicFrameMkLst>
            <pc:docMk/>
            <pc:sldMk cId="98384981" sldId="260"/>
            <ac:graphicFrameMk id="20" creationId="{15628352-6719-4774-9FA9-E8AB0CEF164C}"/>
          </ac:graphicFrameMkLst>
        </pc:graphicFrameChg>
        <pc:graphicFrameChg chg="mod">
          <ac:chgData name="Elder, Matthew" userId="5a922e2c-39ee-4db6-ad0f-3f2e1fe4e1cd" providerId="ADAL" clId="{139CD14C-418A-4282-B912-5F56C6F49A63}" dt="2019-03-27T11:48:01.481" v="144" actId="164"/>
          <ac:graphicFrameMkLst>
            <pc:docMk/>
            <pc:sldMk cId="98384981" sldId="260"/>
            <ac:graphicFrameMk id="24" creationId="{4324A1ED-3557-48BF-B86A-CF0335C3650A}"/>
          </ac:graphicFrameMkLst>
        </pc:graphicFrameChg>
        <pc:graphicFrameChg chg="mod">
          <ac:chgData name="Elder, Matthew" userId="5a922e2c-39ee-4db6-ad0f-3f2e1fe4e1cd" providerId="ADAL" clId="{139CD14C-418A-4282-B912-5F56C6F49A63}" dt="2019-03-27T11:48:01.481" v="144" actId="164"/>
          <ac:graphicFrameMkLst>
            <pc:docMk/>
            <pc:sldMk cId="98384981" sldId="260"/>
            <ac:graphicFrameMk id="25" creationId="{1A1998F5-9680-4D94-BD75-2903B1D626B5}"/>
          </ac:graphicFrameMkLst>
        </pc:graphicFrameChg>
        <pc:graphicFrameChg chg="mod">
          <ac:chgData name="Elder, Matthew" userId="5a922e2c-39ee-4db6-ad0f-3f2e1fe4e1cd" providerId="ADAL" clId="{139CD14C-418A-4282-B912-5F56C6F49A63}" dt="2019-03-27T11:48:01.481" v="144" actId="164"/>
          <ac:graphicFrameMkLst>
            <pc:docMk/>
            <pc:sldMk cId="98384981" sldId="260"/>
            <ac:graphicFrameMk id="26" creationId="{37641D93-100F-4BB8-9BD7-A13CD73380AD}"/>
          </ac:graphicFrameMkLst>
        </pc:graphicFrameChg>
      </pc:sldChg>
      <pc:sldChg chg="addSp delSp modSp add del">
        <pc:chgData name="Elder, Matthew" userId="5a922e2c-39ee-4db6-ad0f-3f2e1fe4e1cd" providerId="ADAL" clId="{139CD14C-418A-4282-B912-5F56C6F49A63}" dt="2019-03-29T13:13:52.699" v="264" actId="2696"/>
        <pc:sldMkLst>
          <pc:docMk/>
          <pc:sldMk cId="3527178327" sldId="265"/>
        </pc:sldMkLst>
        <pc:spChg chg="mod">
          <ac:chgData name="Elder, Matthew" userId="5a922e2c-39ee-4db6-ad0f-3f2e1fe4e1cd" providerId="ADAL" clId="{139CD14C-418A-4282-B912-5F56C6F49A63}" dt="2019-03-29T08:31:55.664" v="260" actId="20577"/>
          <ac:spMkLst>
            <pc:docMk/>
            <pc:sldMk cId="3527178327" sldId="265"/>
            <ac:spMk id="4" creationId="{00000000-0000-0000-0000-000000000000}"/>
          </ac:spMkLst>
        </pc:spChg>
        <pc:spChg chg="mod">
          <ac:chgData name="Elder, Matthew" userId="5a922e2c-39ee-4db6-ad0f-3f2e1fe4e1cd" providerId="ADAL" clId="{139CD14C-418A-4282-B912-5F56C6F49A63}" dt="2019-03-29T08:32:09.931" v="263" actId="20577"/>
          <ac:spMkLst>
            <pc:docMk/>
            <pc:sldMk cId="3527178327" sldId="265"/>
            <ac:spMk id="17" creationId="{00000000-0000-0000-0000-000000000000}"/>
          </ac:spMkLst>
        </pc:spChg>
        <pc:grpChg chg="del">
          <ac:chgData name="Elder, Matthew" userId="5a922e2c-39ee-4db6-ad0f-3f2e1fe4e1cd" providerId="ADAL" clId="{139CD14C-418A-4282-B912-5F56C6F49A63}" dt="2019-03-29T08:16:12.311" v="146" actId="478"/>
          <ac:grpSpMkLst>
            <pc:docMk/>
            <pc:sldMk cId="3527178327" sldId="265"/>
            <ac:grpSpMk id="2" creationId="{00000000-0000-0000-0000-000000000000}"/>
          </ac:grpSpMkLst>
        </pc:grpChg>
        <pc:picChg chg="add del mod">
          <ac:chgData name="Elder, Matthew" userId="5a922e2c-39ee-4db6-ad0f-3f2e1fe4e1cd" providerId="ADAL" clId="{139CD14C-418A-4282-B912-5F56C6F49A63}" dt="2019-03-29T08:20:42.575" v="174" actId="478"/>
          <ac:picMkLst>
            <pc:docMk/>
            <pc:sldMk cId="3527178327" sldId="265"/>
            <ac:picMk id="6" creationId="{ED759C10-5BA3-48BD-98A9-49D50006FAB0}"/>
          </ac:picMkLst>
        </pc:picChg>
        <pc:picChg chg="add mod">
          <ac:chgData name="Elder, Matthew" userId="5a922e2c-39ee-4db6-ad0f-3f2e1fe4e1cd" providerId="ADAL" clId="{139CD14C-418A-4282-B912-5F56C6F49A63}" dt="2019-03-29T08:20:50.991" v="179" actId="1076"/>
          <ac:picMkLst>
            <pc:docMk/>
            <pc:sldMk cId="3527178327" sldId="265"/>
            <ac:picMk id="8" creationId="{1637798A-AC42-4099-9E13-48C07663188B}"/>
          </ac:picMkLst>
        </pc:pic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B1E8EE5-486D-4197-93A8-7BE8FA45C5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11DD86B2-253B-4587-833D-71D5885248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9EED3D2-9A1C-41CB-83A5-481782348F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AF26E8F-641F-4580-BE3A-BB790A066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A44C884-05B8-4092-9E4A-29F6E0E970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19683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106C7B7-CA16-4680-A27E-6695CFB54F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190BE78-1ED3-429C-A529-067C3EC696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C448B74-BEC8-4389-9B00-F0A7ABF76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F2FDCBE-5550-47DC-9133-5FC90DC7A4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0DA1D60-DB1F-4362-A201-1879967DA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8426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15C015AD-6F00-408C-9637-C18A1F3481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1A345F1-7A8F-4390-B928-CF8CE44BA6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AC1D327-05C6-4245-8ED1-699B7617D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B7918D3-0110-4D5F-BE4F-C6ACD9274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8692852-5E21-4153-970C-F777776BA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00211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40409" y="10066268"/>
            <a:ext cx="36724591" cy="69458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480814" y="18362297"/>
            <a:ext cx="30243780" cy="828103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49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99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749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999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24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498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748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998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8287242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8987808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12932" y="20822611"/>
            <a:ext cx="36724591" cy="6435806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12932" y="13734225"/>
            <a:ext cx="36724591" cy="7088384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497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4995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5749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9991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24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4986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7484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99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2180065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506068" y="7560955"/>
            <a:ext cx="76194524" cy="21385175"/>
          </a:xfrm>
        </p:spPr>
        <p:txBody>
          <a:bodyPr/>
          <a:lstStyle>
            <a:lvl1pPr>
              <a:defRPr sz="3100"/>
            </a:lvl1pPr>
            <a:lvl2pPr>
              <a:defRPr sz="28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420681" y="7560955"/>
            <a:ext cx="76194524" cy="21385175"/>
          </a:xfrm>
        </p:spPr>
        <p:txBody>
          <a:bodyPr/>
          <a:lstStyle>
            <a:lvl1pPr>
              <a:defRPr sz="3100"/>
            </a:lvl1pPr>
            <a:lvl2pPr>
              <a:defRPr sz="28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8686322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60274" y="1297665"/>
            <a:ext cx="38884860" cy="5400676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60271" y="7253411"/>
            <a:ext cx="19089888" cy="3022874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24978" indent="0">
              <a:buNone/>
              <a:defRPr sz="2300" b="1"/>
            </a:lvl2pPr>
            <a:lvl3pPr marL="1049954" indent="0">
              <a:buNone/>
              <a:defRPr sz="2000" b="1"/>
            </a:lvl3pPr>
            <a:lvl4pPr marL="1574931" indent="0">
              <a:buNone/>
              <a:defRPr sz="1700" b="1"/>
            </a:lvl4pPr>
            <a:lvl5pPr marL="2099910" indent="0">
              <a:buNone/>
              <a:defRPr sz="1700" b="1"/>
            </a:lvl5pPr>
            <a:lvl6pPr marL="2624886" indent="0">
              <a:buNone/>
              <a:defRPr sz="1700" b="1"/>
            </a:lvl6pPr>
            <a:lvl7pPr marL="3149864" indent="0">
              <a:buNone/>
              <a:defRPr sz="1700" b="1"/>
            </a:lvl7pPr>
            <a:lvl8pPr marL="3674841" indent="0">
              <a:buNone/>
              <a:defRPr sz="1700" b="1"/>
            </a:lvl8pPr>
            <a:lvl9pPr marL="4199818" indent="0">
              <a:buNone/>
              <a:defRPr sz="17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60271" y="10276290"/>
            <a:ext cx="19089888" cy="18669835"/>
          </a:xfrm>
        </p:spPr>
        <p:txBody>
          <a:bodyPr/>
          <a:lstStyle>
            <a:lvl1pPr>
              <a:defRPr sz="2800"/>
            </a:lvl1pPr>
            <a:lvl2pPr>
              <a:defRPr sz="23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947752" y="7253411"/>
            <a:ext cx="19097387" cy="3022874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24978" indent="0">
              <a:buNone/>
              <a:defRPr sz="2300" b="1"/>
            </a:lvl2pPr>
            <a:lvl3pPr marL="1049954" indent="0">
              <a:buNone/>
              <a:defRPr sz="2000" b="1"/>
            </a:lvl3pPr>
            <a:lvl4pPr marL="1574931" indent="0">
              <a:buNone/>
              <a:defRPr sz="1700" b="1"/>
            </a:lvl4pPr>
            <a:lvl5pPr marL="2099910" indent="0">
              <a:buNone/>
              <a:defRPr sz="1700" b="1"/>
            </a:lvl5pPr>
            <a:lvl6pPr marL="2624886" indent="0">
              <a:buNone/>
              <a:defRPr sz="1700" b="1"/>
            </a:lvl6pPr>
            <a:lvl7pPr marL="3149864" indent="0">
              <a:buNone/>
              <a:defRPr sz="1700" b="1"/>
            </a:lvl7pPr>
            <a:lvl8pPr marL="3674841" indent="0">
              <a:buNone/>
              <a:defRPr sz="1700" b="1"/>
            </a:lvl8pPr>
            <a:lvl9pPr marL="4199818" indent="0">
              <a:buNone/>
              <a:defRPr sz="17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947752" y="10276290"/>
            <a:ext cx="19097387" cy="18669835"/>
          </a:xfrm>
        </p:spPr>
        <p:txBody>
          <a:bodyPr/>
          <a:lstStyle>
            <a:lvl1pPr>
              <a:defRPr sz="2800"/>
            </a:lvl1pPr>
            <a:lvl2pPr>
              <a:defRPr sz="23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6144373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0339828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5478935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60276" y="1290164"/>
            <a:ext cx="14214278" cy="5490687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892113" y="1290173"/>
            <a:ext cx="24153020" cy="27655959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60276" y="6780857"/>
            <a:ext cx="14214278" cy="22165272"/>
          </a:xfrm>
        </p:spPr>
        <p:txBody>
          <a:bodyPr/>
          <a:lstStyle>
            <a:lvl1pPr marL="0" indent="0">
              <a:buNone/>
              <a:defRPr sz="1600"/>
            </a:lvl1pPr>
            <a:lvl2pPr marL="524978" indent="0">
              <a:buNone/>
              <a:defRPr sz="1400"/>
            </a:lvl2pPr>
            <a:lvl3pPr marL="1049954" indent="0">
              <a:buNone/>
              <a:defRPr sz="1200"/>
            </a:lvl3pPr>
            <a:lvl4pPr marL="1574931" indent="0">
              <a:buNone/>
              <a:defRPr sz="1000"/>
            </a:lvl4pPr>
            <a:lvl5pPr marL="2099910" indent="0">
              <a:buNone/>
              <a:defRPr sz="1000"/>
            </a:lvl5pPr>
            <a:lvl6pPr marL="2624886" indent="0">
              <a:buNone/>
              <a:defRPr sz="1000"/>
            </a:lvl6pPr>
            <a:lvl7pPr marL="3149864" indent="0">
              <a:buNone/>
              <a:defRPr sz="1000"/>
            </a:lvl7pPr>
            <a:lvl8pPr marL="3674841" indent="0">
              <a:buNone/>
              <a:defRPr sz="1000"/>
            </a:lvl8pPr>
            <a:lvl9pPr marL="4199818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5789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0FB634A-2F92-444C-A650-CE5F9F4F50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3503D55-09E7-4FF0-A9D2-674B9DD015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12B7BF2-22B2-49A9-BBB7-98D9CADE1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A57F1FF-C22C-4295-A067-6A034DF77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FCE1423-EFBB-4004-8338-23AD89C93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2080822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68560" y="22682837"/>
            <a:ext cx="25923240" cy="2677838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8468560" y="2895363"/>
            <a:ext cx="25923240" cy="19442430"/>
          </a:xfrm>
        </p:spPr>
        <p:txBody>
          <a:bodyPr/>
          <a:lstStyle>
            <a:lvl1pPr marL="0" indent="0">
              <a:buNone/>
              <a:defRPr sz="3700"/>
            </a:lvl1pPr>
            <a:lvl2pPr marL="524978" indent="0">
              <a:buNone/>
              <a:defRPr sz="3100"/>
            </a:lvl2pPr>
            <a:lvl3pPr marL="1049954" indent="0">
              <a:buNone/>
              <a:defRPr sz="2800"/>
            </a:lvl3pPr>
            <a:lvl4pPr marL="1574931" indent="0">
              <a:buNone/>
              <a:defRPr sz="2300"/>
            </a:lvl4pPr>
            <a:lvl5pPr marL="2099910" indent="0">
              <a:buNone/>
              <a:defRPr sz="2300"/>
            </a:lvl5pPr>
            <a:lvl6pPr marL="2624886" indent="0">
              <a:buNone/>
              <a:defRPr sz="2300"/>
            </a:lvl6pPr>
            <a:lvl7pPr marL="3149864" indent="0">
              <a:buNone/>
              <a:defRPr sz="2300"/>
            </a:lvl7pPr>
            <a:lvl8pPr marL="3674841" indent="0">
              <a:buNone/>
              <a:defRPr sz="2300"/>
            </a:lvl8pPr>
            <a:lvl9pPr marL="4199818" indent="0">
              <a:buNone/>
              <a:defRPr sz="23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68560" y="25360673"/>
            <a:ext cx="25923240" cy="3802973"/>
          </a:xfrm>
        </p:spPr>
        <p:txBody>
          <a:bodyPr/>
          <a:lstStyle>
            <a:lvl1pPr marL="0" indent="0">
              <a:buNone/>
              <a:defRPr sz="1600"/>
            </a:lvl1pPr>
            <a:lvl2pPr marL="524978" indent="0">
              <a:buNone/>
              <a:defRPr sz="1400"/>
            </a:lvl2pPr>
            <a:lvl3pPr marL="1049954" indent="0">
              <a:buNone/>
              <a:defRPr sz="1200"/>
            </a:lvl3pPr>
            <a:lvl4pPr marL="1574931" indent="0">
              <a:buNone/>
              <a:defRPr sz="1000"/>
            </a:lvl4pPr>
            <a:lvl5pPr marL="2099910" indent="0">
              <a:buNone/>
              <a:defRPr sz="1000"/>
            </a:lvl5pPr>
            <a:lvl6pPr marL="2624886" indent="0">
              <a:buNone/>
              <a:defRPr sz="1000"/>
            </a:lvl6pPr>
            <a:lvl7pPr marL="3149864" indent="0">
              <a:buNone/>
              <a:defRPr sz="1000"/>
            </a:lvl7pPr>
            <a:lvl8pPr marL="3674841" indent="0">
              <a:buNone/>
              <a:defRPr sz="1000"/>
            </a:lvl8pPr>
            <a:lvl9pPr marL="4199818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4712839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2476687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3337926" y="1297675"/>
            <a:ext cx="38277283" cy="2764845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506068" y="1297675"/>
            <a:ext cx="114111766" cy="2764845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73290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1A46B86-F2C3-484D-8603-0F94170718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8B800D3-6497-44B9-992B-7F8C7DE808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2D12FE0-0F23-4944-A304-F3C822D0C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0694040-392D-4001-BB8F-B2B632E71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47A026A-E5E7-4354-9E29-C0A9F3F7A5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56638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59B890E-DA21-4CE3-AF2F-BFD24B1887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326F660-356C-4769-BC65-3838718D65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3D352A8-7F67-4A8C-9394-79114CCBBF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10C8236-E1CE-4BDA-9FD8-DEC76A1DF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8002311-7C0C-4178-9366-836195D3F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5459AFF-E0DF-4548-85BB-A608F9AF3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34513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20F37AF-A9A4-4D3D-9F87-5AB0BDD419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B79D6D0-7274-41DA-B6E1-3417BA5CF1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C8CED3E-F901-4BB4-A18D-318D6C19A0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72283A69-5B0F-4488-80D5-7CE9D23AA1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EE37D3DC-FB1F-4A50-8A74-E6CB8ED6A0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A0985C05-DAAF-4FD2-8C22-27EAB9B42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D8CF7F39-A3D6-4186-9904-C65E5CECE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AC89E1D4-0350-4881-80C4-48E6EA74C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64344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8FC71E1-19F4-4086-BDB4-F1D3BB6635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BC14ACF9-5925-4E6A-B44D-AA323D066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AE553E20-2AA2-458F-8AAC-1387C36BB3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21CA967F-9EA9-405D-A920-874D3A781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08811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73F00A91-D3CF-4A0C-BFF0-3304231BD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E0A38FE7-AF6C-4733-9CC9-9E79EAE66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8AE0C877-773D-459C-8766-AE0E018766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11002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E4963A2-1E35-414E-8717-8EEF173671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8747689-434B-41B8-95F4-52DCB1C74E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B9A6C11D-115C-490E-8DDC-36CF29D626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074EBC7-30EF-4F75-9A41-D588E03ED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B549219-FA4B-44A9-9C50-2BF7754AA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B378D1D-B4C5-4BB2-94D7-5A339749E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62892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99A3728-6F77-4ABD-9785-93EB0CA8DA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A22E6B67-AB23-414E-80F1-EB530183B9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C21D991-9FA5-4CE6-BCF3-68BEE1D2E6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624F6ED-23A4-4F7A-B746-35D78BD01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1FF19E3-145A-4B63-85D1-8E2AA9E3E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21F0564-8907-4EB4-9E1E-73861BA56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34907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4988002E-E8B0-40B2-BA9A-2C7864F788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9E21065-76BB-4367-9E7F-CF31509A8B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0088E4B-C2D1-48B8-AB05-EEBA07F6D7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987EA-A3A6-474B-885A-5B66B5BF3F9A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3530480-38FB-4F54-A012-3068E88E34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A2BDF33-DAAC-4712-BB42-277643D2B8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10C0AC-341C-42DB-97BD-29E5ABBE700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445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60274" y="1297665"/>
            <a:ext cx="38884860" cy="5400676"/>
          </a:xfrm>
          <a:prstGeom prst="rect">
            <a:avLst/>
          </a:prstGeom>
        </p:spPr>
        <p:txBody>
          <a:bodyPr vert="horz" lIns="104995" tIns="52497" rIns="104995" bIns="52497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60274" y="7560955"/>
            <a:ext cx="38884860" cy="21385175"/>
          </a:xfrm>
          <a:prstGeom prst="rect">
            <a:avLst/>
          </a:prstGeom>
        </p:spPr>
        <p:txBody>
          <a:bodyPr vert="horz" lIns="104995" tIns="52497" rIns="104995" bIns="52497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60274" y="30033766"/>
            <a:ext cx="10081260" cy="1725215"/>
          </a:xfrm>
          <a:prstGeom prst="rect">
            <a:avLst/>
          </a:prstGeom>
        </p:spPr>
        <p:txBody>
          <a:bodyPr vert="horz" lIns="104995" tIns="52497" rIns="104995" bIns="52497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C134E-D07A-4A59-923F-3EA0CD975C07}" type="datetimeFigureOut">
              <a:rPr lang="en-GB" smtClean="0"/>
              <a:t>02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761849" y="30033766"/>
            <a:ext cx="13681711" cy="1725215"/>
          </a:xfrm>
          <a:prstGeom prst="rect">
            <a:avLst/>
          </a:prstGeom>
        </p:spPr>
        <p:txBody>
          <a:bodyPr vert="horz" lIns="104995" tIns="52497" rIns="104995" bIns="52497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963874" y="30033766"/>
            <a:ext cx="10081260" cy="1725215"/>
          </a:xfrm>
          <a:prstGeom prst="rect">
            <a:avLst/>
          </a:prstGeom>
        </p:spPr>
        <p:txBody>
          <a:bodyPr vert="horz" lIns="104995" tIns="52497" rIns="104995" bIns="52497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E54FF-9AD0-41D3-8C54-0B89E31F95B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94168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1049954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3732" indent="-393732" algn="l" defTabSz="1049954" rtl="0" eaLnBrk="1" latinLnBrk="0" hangingPunct="1">
        <a:spcBef>
          <a:spcPct val="20000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53087" indent="-328110" algn="l" defTabSz="1049954" rtl="0" eaLnBrk="1" latinLnBrk="0" hangingPunct="1">
        <a:spcBef>
          <a:spcPct val="20000"/>
        </a:spcBef>
        <a:buFont typeface="Arial" panose="020B0604020202020204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312445" indent="-262488" algn="l" defTabSz="104995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37421" indent="-262488" algn="l" defTabSz="1049954" rtl="0" eaLnBrk="1" latinLnBrk="0" hangingPunct="1">
        <a:spcBef>
          <a:spcPct val="20000"/>
        </a:spcBef>
        <a:buFont typeface="Arial" panose="020B0604020202020204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62399" indent="-262488" algn="l" defTabSz="1049954" rtl="0" eaLnBrk="1" latinLnBrk="0" hangingPunct="1">
        <a:spcBef>
          <a:spcPct val="20000"/>
        </a:spcBef>
        <a:buFont typeface="Arial" panose="020B0604020202020204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87375" indent="-262488" algn="l" defTabSz="1049954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412353" indent="-262488" algn="l" defTabSz="1049954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37330" indent="-262488" algn="l" defTabSz="1049954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62309" indent="-262488" algn="l" defTabSz="1049954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995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24978" algn="l" defTabSz="104995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49954" algn="l" defTabSz="104995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74931" algn="l" defTabSz="104995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99910" algn="l" defTabSz="104995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624886" algn="l" defTabSz="104995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149864" algn="l" defTabSz="104995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674841" algn="l" defTabSz="104995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199818" algn="l" defTabSz="104995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0.emf"/><Relationship Id="rId4" Type="http://schemas.openxmlformats.org/officeDocument/2006/relationships/image" Target="../media/image7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tiff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493722" y="317648"/>
            <a:ext cx="36281900" cy="1000266"/>
          </a:xfrm>
          <a:prstGeom prst="rect">
            <a:avLst/>
          </a:prstGeom>
        </p:spPr>
        <p:txBody>
          <a:bodyPr wrap="none" lIns="91430" tIns="45716" rIns="91430" bIns="45716">
            <a:spAutoFit/>
          </a:bodyPr>
          <a:lstStyle/>
          <a:p>
            <a:pPr algn="ctr">
              <a:spcBef>
                <a:spcPct val="0"/>
              </a:spcBef>
            </a:pPr>
            <a:r>
              <a:rPr lang="en-GB" sz="5900" b="1" dirty="0"/>
              <a:t>Supplemental Figure 1- Increased IL-1</a:t>
            </a:r>
            <a:r>
              <a:rPr lang="el-GR" sz="5900" b="1" dirty="0"/>
              <a:t>β</a:t>
            </a:r>
            <a:r>
              <a:rPr lang="en-GB" sz="5900" b="1" dirty="0"/>
              <a:t>, IL-6 and IL-23 observed with TSLPR </a:t>
            </a:r>
            <a:r>
              <a:rPr lang="en-GB" sz="5900" b="1" dirty="0" smtClean="0"/>
              <a:t>neutralization </a:t>
            </a:r>
            <a:r>
              <a:rPr lang="en-GB" sz="5900" b="1" dirty="0"/>
              <a:t>requires dectin-1 and Syk</a:t>
            </a:r>
            <a:endParaRPr lang="en-GB" sz="5900" dirty="0"/>
          </a:p>
        </p:txBody>
      </p:sp>
      <p:grpSp>
        <p:nvGrpSpPr>
          <p:cNvPr id="2" name="Group 1"/>
          <p:cNvGrpSpPr/>
          <p:nvPr/>
        </p:nvGrpSpPr>
        <p:grpSpPr>
          <a:xfrm>
            <a:off x="13609812" y="3024561"/>
            <a:ext cx="17203295" cy="15086897"/>
            <a:chOff x="13033002" y="6569155"/>
            <a:chExt cx="17203295" cy="15086897"/>
          </a:xfrm>
        </p:grpSpPr>
        <p:grpSp>
          <p:nvGrpSpPr>
            <p:cNvPr id="3" name="Group 2"/>
            <p:cNvGrpSpPr/>
            <p:nvPr/>
          </p:nvGrpSpPr>
          <p:grpSpPr>
            <a:xfrm>
              <a:off x="13033002" y="6569155"/>
              <a:ext cx="17203295" cy="15086897"/>
              <a:chOff x="10729492" y="8120927"/>
              <a:chExt cx="17203295" cy="15086897"/>
            </a:xfrm>
          </p:grpSpPr>
          <p:pic>
            <p:nvPicPr>
              <p:cNvPr id="1026" name="Picture 2" descr="V:\Matt adn TSLP project\aTSLP Paper\Supplemental Figure 2\a_IL-1_aDectin-1_graph.tif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729492" y="8137129"/>
                <a:ext cx="6044696" cy="722182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7" name="Picture 3" descr="V:\Matt adn TSLP project\aTSLP Paper\Supplemental Figure 2\a_IL-6_aDectin-1_graph.tif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202100" y="8137129"/>
                <a:ext cx="6231606" cy="722182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8" name="Picture 4" descr="V:\Matt adn TSLP project\aTSLP Paper\Supplemental Figure 2\a_IL-23_aDectin-1_graph.tif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884115" y="8120927"/>
                <a:ext cx="6048672" cy="722182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9" name="Picture 5" descr="V:\Matt adn TSLP project\aTSLP Paper\Supplemental Figure 2\a_IL-1_Syk-i_graph.tif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729492" y="15986001"/>
                <a:ext cx="6140139" cy="722182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0" name="Picture 6" descr="V:\Matt adn TSLP project\aTSLP Paper\Supplemental Figure 2\a_IL-6_Syk-i_graph.tif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202100" y="15986002"/>
                <a:ext cx="6231606" cy="722182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1" name="Picture 7" descr="V:\Matt adn TSLP project\aTSLP Paper\Supplemental Figure 2\a_IL-23_Syk-i_graph.tif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884115" y="15986002"/>
                <a:ext cx="6048672" cy="722182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10" name="TextBox 2"/>
            <p:cNvSpPr txBox="1">
              <a:spLocks noChangeArrowheads="1"/>
            </p:cNvSpPr>
            <p:nvPr/>
          </p:nvSpPr>
          <p:spPr bwMode="auto">
            <a:xfrm>
              <a:off x="25157518" y="14418029"/>
              <a:ext cx="732893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F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11" name="TextBox 2"/>
            <p:cNvSpPr txBox="1">
              <a:spLocks noChangeArrowheads="1"/>
            </p:cNvSpPr>
            <p:nvPr/>
          </p:nvSpPr>
          <p:spPr bwMode="auto">
            <a:xfrm>
              <a:off x="13876681" y="14434228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D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12" name="TextBox 2"/>
            <p:cNvSpPr txBox="1">
              <a:spLocks noChangeArrowheads="1"/>
            </p:cNvSpPr>
            <p:nvPr/>
          </p:nvSpPr>
          <p:spPr bwMode="auto">
            <a:xfrm>
              <a:off x="19532697" y="14447547"/>
              <a:ext cx="78418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E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13" name="TextBox 2"/>
            <p:cNvSpPr txBox="1">
              <a:spLocks noChangeArrowheads="1"/>
            </p:cNvSpPr>
            <p:nvPr/>
          </p:nvSpPr>
          <p:spPr bwMode="auto">
            <a:xfrm>
              <a:off x="25056257" y="6585356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C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14" name="TextBox 2"/>
            <p:cNvSpPr txBox="1">
              <a:spLocks noChangeArrowheads="1"/>
            </p:cNvSpPr>
            <p:nvPr/>
          </p:nvSpPr>
          <p:spPr bwMode="auto">
            <a:xfrm>
              <a:off x="19507851" y="6585356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B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15" name="TextBox 2"/>
            <p:cNvSpPr txBox="1">
              <a:spLocks noChangeArrowheads="1"/>
            </p:cNvSpPr>
            <p:nvPr/>
          </p:nvSpPr>
          <p:spPr bwMode="auto">
            <a:xfrm>
              <a:off x="13825836" y="6585356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A</a:t>
              </a:r>
              <a:endParaRPr lang="en-GB" altLang="en-US" sz="7000" b="1" dirty="0">
                <a:latin typeface="Arial" charset="0"/>
              </a:endParaRPr>
            </a:p>
          </p:txBody>
        </p:sp>
      </p:grpSp>
      <p:sp>
        <p:nvSpPr>
          <p:cNvPr id="17" name="Rectangle 16"/>
          <p:cNvSpPr>
            <a:spLocks noChangeArrowheads="1"/>
          </p:cNvSpPr>
          <p:nvPr/>
        </p:nvSpPr>
        <p:spPr bwMode="auto">
          <a:xfrm>
            <a:off x="720380" y="21962665"/>
            <a:ext cx="41764640" cy="42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algn="just"/>
            <a:r>
              <a:rPr lang="en-GB" altLang="en-US" sz="5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reased IL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L-6 and IL-23 observed with TSLPR </a:t>
            </a:r>
            <a:r>
              <a:rPr lang="en-GB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utralization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quires dectin-1 and Syk.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F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DC stimulated with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</a:rPr>
              <a:t> SC glucan for 24 </a:t>
            </a:r>
            <a:r>
              <a:rPr lang="en-GB" sz="54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hours were 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</a:rPr>
              <a:t>pre-incubated with either anti-dectin-1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C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</a:rPr>
              <a:t>or Syk inhibitor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,E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sz="54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</a:rPr>
              <a:t>in the presence or absence of anti-TSLPR, (n=</a:t>
            </a:r>
            <a:r>
              <a:rPr lang="en-GB" sz="5400" dirty="0">
                <a:latin typeface="Times New Roman" panose="02020603050405020304" pitchFamily="18" charset="0"/>
              </a:rPr>
              <a:t>4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</a:rPr>
              <a:t>independent donors, presented as pooled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</a:rPr>
              <a:t>).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</a:rPr>
              <a:t>IL-1β, IL-6 and IL-23 was measured in 24-hour cell culture supernatants by ELISA.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mulative data displayed as mean </a:t>
            </a:r>
            <a:r>
              <a:rPr lang="en-GB" altLang="en-US" sz="5400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M. Statistical analysis calculated using t test. p values are </a:t>
            </a:r>
            <a:r>
              <a:rPr lang="en-GB" altLang="en-US" sz="48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48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altLang="en-US" sz="48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altLang="en-US" sz="4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0.0005, </a:t>
            </a:r>
            <a:r>
              <a:rPr lang="en-GB" altLang="en-US" sz="48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48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altLang="en-US" sz="48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altLang="en-US" sz="4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0.0076,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0.0481,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0.0095,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0.0074,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0.0432</a:t>
            </a:r>
            <a:endParaRPr lang="en-GB" altLang="en-US" sz="5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74291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118342" y="317648"/>
            <a:ext cx="27032701" cy="1000266"/>
          </a:xfrm>
          <a:prstGeom prst="rect">
            <a:avLst/>
          </a:prstGeom>
        </p:spPr>
        <p:txBody>
          <a:bodyPr wrap="none" lIns="91430" tIns="45716" rIns="91430" bIns="45716">
            <a:spAutoFit/>
          </a:bodyPr>
          <a:lstStyle/>
          <a:p>
            <a:pPr algn="ctr">
              <a:spcBef>
                <a:spcPct val="0"/>
              </a:spcBef>
            </a:pPr>
            <a:r>
              <a:rPr lang="en-GB" sz="5900" b="1" dirty="0"/>
              <a:t>Supplemental Figure 2 – </a:t>
            </a:r>
            <a:r>
              <a:rPr lang="el-GR" sz="5900" b="1" dirty="0"/>
              <a:t>β</a:t>
            </a:r>
            <a:r>
              <a:rPr lang="en-GB" sz="5900" b="1" dirty="0"/>
              <a:t>-glucan induced IL-1β is required for IL-6 and IL-23 secretion</a:t>
            </a:r>
            <a:endParaRPr lang="en-GB" sz="5900" dirty="0"/>
          </a:p>
        </p:txBody>
      </p:sp>
      <p:sp>
        <p:nvSpPr>
          <p:cNvPr id="22" name="Rectangle 21"/>
          <p:cNvSpPr>
            <a:spLocks noChangeArrowheads="1"/>
          </p:cNvSpPr>
          <p:nvPr/>
        </p:nvSpPr>
        <p:spPr bwMode="auto">
          <a:xfrm>
            <a:off x="720380" y="23920270"/>
            <a:ext cx="41764640" cy="42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algn="just"/>
            <a:r>
              <a:rPr lang="en-GB" altLang="en-US" sz="5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 </a:t>
            </a:r>
            <a:r>
              <a:rPr lang="en-GB" sz="5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glucan induced IL-1β is required for IL-6 and IL-23 secretion.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D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mDC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were stimulated with SC glucan,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pro-IL-1β, IL-6, Il-23p19 and IL-23p40 mRNA expression was measured over time relative to HPRT expression by quantitative real-time PCR.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,F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mDC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were stimulated with SC glucan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the presence or absence of IL-RA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24 hours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=4 independent donors, presented as pooled data). IL-6 and IL-23 was measured in 24-hour cell culture supernatants by ELISA. 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umulative data displayed as mean </a:t>
            </a:r>
            <a:r>
              <a:rPr lang="en-GB" sz="5400" u="sng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M. Statistical analysis calculated using one-way ANOVA with Bonferroni post-tests (**** p=0.0001 and ** p=0.01).</a:t>
            </a:r>
            <a:endParaRPr lang="en-GB" altLang="en-US" sz="54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E861D3E3-DD93-4949-A7E8-CEFF3D17CD01}"/>
              </a:ext>
            </a:extLst>
          </p:cNvPr>
          <p:cNvGrpSpPr/>
          <p:nvPr/>
        </p:nvGrpSpPr>
        <p:grpSpPr>
          <a:xfrm>
            <a:off x="6985076" y="2821956"/>
            <a:ext cx="29163240" cy="21106603"/>
            <a:chOff x="6985076" y="2821956"/>
            <a:chExt cx="29163240" cy="21106603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xmlns="" id="{4CB13A46-2E7E-44C2-B748-3F4E4C368D1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17007193"/>
                </p:ext>
              </p:extLst>
            </p:nvPr>
          </p:nvGraphicFramePr>
          <p:xfrm>
            <a:off x="13969852" y="12961665"/>
            <a:ext cx="6955531" cy="1096689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8" name="Prism 8" r:id="rId3" imgW="2058579" imgH="3245774" progId="Prism8.Document">
                    <p:embed/>
                  </p:oleObj>
                </mc:Choice>
                <mc:Fallback>
                  <p:oleObj name="Prism 8" r:id="rId3" imgW="2058579" imgH="3245774" progId="Prism8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xmlns="" id="{4CB13A46-2E7E-44C2-B748-3F4E4C368D1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3969852" y="12961665"/>
                          <a:ext cx="6955531" cy="1096689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xmlns="" id="{5BE6129B-6D0A-48DE-8583-B91522B7FA2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08094550"/>
                </p:ext>
              </p:extLst>
            </p:nvPr>
          </p:nvGraphicFramePr>
          <p:xfrm>
            <a:off x="21976194" y="12961665"/>
            <a:ext cx="6955531" cy="1096689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9" name="Prism 8" r:id="rId5" imgW="2058579" imgH="3245774" progId="Prism8.Document">
                    <p:embed/>
                  </p:oleObj>
                </mc:Choice>
                <mc:Fallback>
                  <p:oleObj name="Prism 8" r:id="rId5" imgW="2058579" imgH="3245774" progId="Prism8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xmlns="" id="{5BE6129B-6D0A-48DE-8583-B91522B7FA2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1976194" y="12961665"/>
                          <a:ext cx="6955531" cy="1096689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Object 23">
              <a:extLst>
                <a:ext uri="{FF2B5EF4-FFF2-40B4-BE49-F238E27FC236}">
                  <a16:creationId xmlns:a16="http://schemas.microsoft.com/office/drawing/2014/main" xmlns="" id="{4324A1ED-3557-48BF-B86A-CF0335C3650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42876578"/>
                </p:ext>
              </p:extLst>
            </p:nvPr>
          </p:nvGraphicFramePr>
          <p:xfrm>
            <a:off x="14346238" y="3355975"/>
            <a:ext cx="6961187" cy="9313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0" name="Prism 8" r:id="rId7" imgW="2060018" imgH="2758026" progId="Prism8.Document">
                    <p:embed/>
                  </p:oleObj>
                </mc:Choice>
                <mc:Fallback>
                  <p:oleObj name="Prism 8" r:id="rId7" imgW="2060018" imgH="2758026" progId="Prism8.Document">
                    <p:embed/>
                    <p:pic>
                      <p:nvPicPr>
                        <p:cNvPr id="24" name="Object 23">
                          <a:extLst>
                            <a:ext uri="{FF2B5EF4-FFF2-40B4-BE49-F238E27FC236}">
                              <a16:creationId xmlns:a16="http://schemas.microsoft.com/office/drawing/2014/main" xmlns="" id="{4324A1ED-3557-48BF-B86A-CF0335C3650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4346238" y="3355975"/>
                          <a:ext cx="6961187" cy="9313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Object 24">
              <a:extLst>
                <a:ext uri="{FF2B5EF4-FFF2-40B4-BE49-F238E27FC236}">
                  <a16:creationId xmlns:a16="http://schemas.microsoft.com/office/drawing/2014/main" xmlns="" id="{1A1998F5-9680-4D94-BD75-2903B1D626B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22822049"/>
                </p:ext>
              </p:extLst>
            </p:nvPr>
          </p:nvGraphicFramePr>
          <p:xfrm>
            <a:off x="21320818" y="3098800"/>
            <a:ext cx="7373937" cy="9829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1" name="Prism 8" r:id="rId9" imgW="2182043" imgH="2910650" progId="Prism8.Document">
                    <p:embed/>
                  </p:oleObj>
                </mc:Choice>
                <mc:Fallback>
                  <p:oleObj name="Prism 8" r:id="rId9" imgW="2182043" imgH="2910650" progId="Prism8.Document">
                    <p:embed/>
                    <p:pic>
                      <p:nvPicPr>
                        <p:cNvPr id="25" name="Object 24">
                          <a:extLst>
                            <a:ext uri="{FF2B5EF4-FFF2-40B4-BE49-F238E27FC236}">
                              <a16:creationId xmlns:a16="http://schemas.microsoft.com/office/drawing/2014/main" xmlns="" id="{1A1998F5-9680-4D94-BD75-2903B1D626B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1320818" y="3098800"/>
                          <a:ext cx="7373937" cy="9829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xmlns="" id="{37641D93-100F-4BB8-9BD7-A13CD73380A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68968990"/>
                </p:ext>
              </p:extLst>
            </p:nvPr>
          </p:nvGraphicFramePr>
          <p:xfrm>
            <a:off x="28774378" y="3095625"/>
            <a:ext cx="7373938" cy="9829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2" name="Prism 8" r:id="rId11" imgW="2182043" imgH="2910650" progId="Prism8.Document">
                    <p:embed/>
                  </p:oleObj>
                </mc:Choice>
                <mc:Fallback>
                  <p:oleObj name="Prism 8" r:id="rId11" imgW="2182043" imgH="2910650" progId="Prism8.Document">
                    <p:embed/>
                    <p:pic>
                      <p:nvPicPr>
                        <p:cNvPr id="26" name="Object 25">
                          <a:extLst>
                            <a:ext uri="{FF2B5EF4-FFF2-40B4-BE49-F238E27FC236}">
                              <a16:creationId xmlns:a16="http://schemas.microsoft.com/office/drawing/2014/main" xmlns="" id="{37641D93-100F-4BB8-9BD7-A13CD73380A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8774378" y="3095625"/>
                          <a:ext cx="7373938" cy="9829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1" name="TextBox 2">
              <a:extLst>
                <a:ext uri="{FF2B5EF4-FFF2-40B4-BE49-F238E27FC236}">
                  <a16:creationId xmlns:a16="http://schemas.microsoft.com/office/drawing/2014/main" xmlns="" id="{3BFF1DB6-0686-4AF3-8805-71AC9A87A6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984116" y="13361608"/>
              <a:ext cx="78418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E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32" name="TextBox 2">
              <a:extLst>
                <a:ext uri="{FF2B5EF4-FFF2-40B4-BE49-F238E27FC236}">
                  <a16:creationId xmlns:a16="http://schemas.microsoft.com/office/drawing/2014/main" xmlns="" id="{6A1907C9-591F-4D2D-8F83-D75DDF2469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77004" y="13361608"/>
              <a:ext cx="732893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F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33" name="TextBox 2">
              <a:extLst>
                <a:ext uri="{FF2B5EF4-FFF2-40B4-BE49-F238E27FC236}">
                  <a16:creationId xmlns:a16="http://schemas.microsoft.com/office/drawing/2014/main" xmlns="" id="{0CEF9C00-563F-43D2-9B13-49B6C197AA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29292" y="2821956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A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34" name="TextBox 2">
              <a:extLst>
                <a:ext uri="{FF2B5EF4-FFF2-40B4-BE49-F238E27FC236}">
                  <a16:creationId xmlns:a16="http://schemas.microsoft.com/office/drawing/2014/main" xmlns="" id="{628C84DA-A60F-4BB6-A6A5-99845C4F51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787448" y="2857634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B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35" name="TextBox 2">
              <a:extLst>
                <a:ext uri="{FF2B5EF4-FFF2-40B4-BE49-F238E27FC236}">
                  <a16:creationId xmlns:a16="http://schemas.microsoft.com/office/drawing/2014/main" xmlns="" id="{29C4A3DA-B6AC-4C84-9A69-2E6441E0CD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191446" y="2857634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C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36" name="TextBox 2">
              <a:extLst>
                <a:ext uri="{FF2B5EF4-FFF2-40B4-BE49-F238E27FC236}">
                  <a16:creationId xmlns:a16="http://schemas.microsoft.com/office/drawing/2014/main" xmlns="" id="{89C05798-6610-4A0A-8022-2286B93B9C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715406" y="2857634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D</a:t>
              </a:r>
              <a:endParaRPr lang="en-GB" altLang="en-US" sz="7000" b="1" dirty="0">
                <a:latin typeface="Arial" charset="0"/>
              </a:endParaRPr>
            </a:p>
          </p:txBody>
        </p:sp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xmlns="" id="{44D6D6DB-B26F-451B-B9B1-27C7597E79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2000909"/>
                </p:ext>
              </p:extLst>
            </p:nvPr>
          </p:nvGraphicFramePr>
          <p:xfrm>
            <a:off x="6985076" y="3355975"/>
            <a:ext cx="7304785" cy="931765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3" name="Prism 8" r:id="rId13" imgW="2143888" imgH="2733908" progId="Prism8.Document">
                    <p:embed/>
                  </p:oleObj>
                </mc:Choice>
                <mc:Fallback>
                  <p:oleObj name="Prism 8" r:id="rId13" imgW="2143888" imgH="2733908" progId="Prism8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xmlns="" id="{44D6D6DB-B26F-451B-B9B1-27C7597E792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6985076" y="3355975"/>
                          <a:ext cx="7304785" cy="931765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983849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952691" y="317648"/>
            <a:ext cx="31363951" cy="1000266"/>
          </a:xfrm>
          <a:prstGeom prst="rect">
            <a:avLst/>
          </a:prstGeom>
        </p:spPr>
        <p:txBody>
          <a:bodyPr wrap="none" lIns="91430" tIns="45716" rIns="91430" bIns="45716">
            <a:spAutoFit/>
          </a:bodyPr>
          <a:lstStyle/>
          <a:p>
            <a:pPr algn="ctr">
              <a:spcBef>
                <a:spcPct val="0"/>
              </a:spcBef>
            </a:pPr>
            <a:r>
              <a:rPr lang="en-GB" sz="5900" b="1" dirty="0"/>
              <a:t>Supplemental Figure 3 – Lactate, IL-1</a:t>
            </a:r>
            <a:r>
              <a:rPr lang="el-GR" sz="5900" b="1"/>
              <a:t>β</a:t>
            </a:r>
            <a:r>
              <a:rPr lang="en-GB" sz="5900" b="1" dirty="0"/>
              <a:t> and HIF-1</a:t>
            </a:r>
            <a:r>
              <a:rPr lang="el-GR" sz="5900" b="1"/>
              <a:t>α</a:t>
            </a:r>
            <a:r>
              <a:rPr lang="en-GB" sz="5900" b="1" dirty="0"/>
              <a:t> are elevated in dectin-1-stimulated TSLPR</a:t>
            </a:r>
            <a:r>
              <a:rPr lang="en-GB" sz="5900" b="1" baseline="30000" dirty="0"/>
              <a:t>-/- </a:t>
            </a:r>
            <a:r>
              <a:rPr lang="en-GB" sz="5900" b="1" dirty="0"/>
              <a:t>BMDC</a:t>
            </a:r>
            <a:endParaRPr lang="en-GB" sz="5900" dirty="0"/>
          </a:p>
        </p:txBody>
      </p:sp>
      <p:sp>
        <p:nvSpPr>
          <p:cNvPr id="22" name="Rectangle 21"/>
          <p:cNvSpPr>
            <a:spLocks noChangeArrowheads="1"/>
          </p:cNvSpPr>
          <p:nvPr/>
        </p:nvSpPr>
        <p:spPr bwMode="auto">
          <a:xfrm>
            <a:off x="720380" y="21962665"/>
            <a:ext cx="41764640" cy="507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algn="just"/>
            <a:r>
              <a:rPr lang="en-GB" altLang="en-US" sz="5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 </a:t>
            </a:r>
            <a:r>
              <a:rPr lang="en-GB" sz="5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ate, IL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HIF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elevated in dectin-1-stimulated TSLPR</a:t>
            </a:r>
            <a:r>
              <a:rPr lang="en-GB" sz="5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DC.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rine BMDC </a:t>
            </a:r>
            <a:r>
              <a:rPr lang="en-GB" altLang="en-US" sz="5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erived from wildtype TSLPR</a:t>
            </a:r>
            <a:r>
              <a:rPr lang="en-GB" altLang="en-US" sz="5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/+</a:t>
            </a:r>
            <a:r>
              <a:rPr lang="en-GB" altLang="en-US" sz="5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or TSLPR</a:t>
            </a:r>
            <a:r>
              <a:rPr lang="en-GB" altLang="en-US" sz="5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-/-</a:t>
            </a:r>
            <a:r>
              <a:rPr lang="en-GB" altLang="en-US" sz="5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BALB/c mice 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timulated SC glucan, </a:t>
            </a:r>
            <a:r>
              <a:rPr lang="en-GB" sz="54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or 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4 hours (n=3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</a:rPr>
              <a:t>independent animals, presented as pooled data). L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ate production was measured in cell-culture supernatants by </a:t>
            </a:r>
            <a:r>
              <a:rPr lang="en-GB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rimetric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lactate detection kit.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rine BMDC </a:t>
            </a:r>
            <a:r>
              <a:rPr lang="en-GB" altLang="en-US" sz="5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erived from wildtype TSLPR</a:t>
            </a:r>
            <a:r>
              <a:rPr lang="en-GB" altLang="en-US" sz="5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/+</a:t>
            </a:r>
            <a:r>
              <a:rPr lang="en-GB" altLang="en-US" sz="5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or TSLPR</a:t>
            </a:r>
            <a:r>
              <a:rPr lang="en-GB" altLang="en-US" sz="5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-/-</a:t>
            </a:r>
            <a:r>
              <a:rPr lang="en-GB" altLang="en-US" sz="5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BALB/c mice 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timulated SC glucan for eight hours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 representative donor presented, two separate experiments performed)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IL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IF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 were detected by immunoblot.</a:t>
            </a:r>
            <a:r>
              <a:rPr lang="en-GB" sz="5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data displayed as mean </a:t>
            </a:r>
            <a:r>
              <a:rPr lang="en-GB" sz="54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. Statistical analysis calculated using one-way ANOVA with Bonferroni post-tests </a:t>
            </a:r>
            <a:r>
              <a:rPr lang="en-GB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5). </a:t>
            </a:r>
            <a:endParaRPr lang="en-GB" sz="54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14324422" y="7818819"/>
            <a:ext cx="16984441" cy="9690012"/>
            <a:chOff x="5832202" y="6095758"/>
            <a:chExt cx="16984441" cy="9690012"/>
          </a:xfrm>
        </p:grpSpPr>
        <p:grpSp>
          <p:nvGrpSpPr>
            <p:cNvPr id="5" name="Group 4"/>
            <p:cNvGrpSpPr/>
            <p:nvPr/>
          </p:nvGrpSpPr>
          <p:grpSpPr>
            <a:xfrm>
              <a:off x="12945412" y="6095758"/>
              <a:ext cx="9871231" cy="8422987"/>
              <a:chOff x="6449846" y="8137129"/>
              <a:chExt cx="9871231" cy="8422987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7489132" y="8137129"/>
                <a:ext cx="8831945" cy="8422987"/>
                <a:chOff x="18616608" y="11744413"/>
                <a:chExt cx="8831945" cy="8422987"/>
              </a:xfrm>
            </p:grpSpPr>
            <p:grpSp>
              <p:nvGrpSpPr>
                <p:cNvPr id="3" name="Group 2"/>
                <p:cNvGrpSpPr/>
                <p:nvPr/>
              </p:nvGrpSpPr>
              <p:grpSpPr>
                <a:xfrm>
                  <a:off x="18616608" y="11744413"/>
                  <a:ext cx="6403062" cy="6713443"/>
                  <a:chOff x="18616608" y="11744413"/>
                  <a:chExt cx="6403062" cy="6713443"/>
                </a:xfrm>
              </p:grpSpPr>
              <p:pic>
                <p:nvPicPr>
                  <p:cNvPr id="2050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8616611" y="15901708"/>
                    <a:ext cx="5972175" cy="1152525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pic>
                <p:nvPicPr>
                  <p:cNvPr id="2051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8616608" y="17305331"/>
                    <a:ext cx="5972175" cy="1152525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pic>
                <p:nvPicPr>
                  <p:cNvPr id="2052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8616609" y="14545841"/>
                    <a:ext cx="5972175" cy="1152525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sp>
                <p:nvSpPr>
                  <p:cNvPr id="8" name="TextBox 240"/>
                  <p:cNvSpPr txBox="1"/>
                  <p:nvPr/>
                </p:nvSpPr>
                <p:spPr bwMode="auto">
                  <a:xfrm rot="18835675">
                    <a:off x="23261336" y="12859980"/>
                    <a:ext cx="2654894" cy="861774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>
                    <a:defPPr>
                      <a:defRPr lang="en-US"/>
                    </a:defPPr>
                    <a:lvl1pPr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1pPr>
                    <a:lvl2pPr marL="4572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2pPr>
                    <a:lvl3pPr marL="9144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3pPr>
                    <a:lvl4pPr marL="13716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4pPr>
                    <a:lvl5pPr marL="18288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defRPr/>
                    </a:pPr>
                    <a:r>
                      <a:rPr lang="en-GB" sz="5000" dirty="0">
                        <a:latin typeface="Arial" pitchFamily="34" charset="0"/>
                        <a:cs typeface="Arial" pitchFamily="34" charset="0"/>
                      </a:rPr>
                      <a:t>TSLPR</a:t>
                    </a:r>
                    <a:r>
                      <a:rPr lang="en-GB" sz="5000" baseline="30000" dirty="0">
                        <a:latin typeface="Arial" pitchFamily="34" charset="0"/>
                        <a:cs typeface="Arial" pitchFamily="34" charset="0"/>
                      </a:rPr>
                      <a:t>-/-</a:t>
                    </a:r>
                  </a:p>
                </p:txBody>
              </p:sp>
              <p:sp>
                <p:nvSpPr>
                  <p:cNvPr id="9" name="TextBox 240"/>
                  <p:cNvSpPr txBox="1"/>
                  <p:nvPr/>
                </p:nvSpPr>
                <p:spPr bwMode="auto">
                  <a:xfrm rot="18835675">
                    <a:off x="20101146" y="12825725"/>
                    <a:ext cx="2654894" cy="861774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>
                    <a:defPPr>
                      <a:defRPr lang="en-US"/>
                    </a:defPPr>
                    <a:lvl1pPr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1pPr>
                    <a:lvl2pPr marL="4572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2pPr>
                    <a:lvl3pPr marL="9144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3pPr>
                    <a:lvl4pPr marL="13716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4pPr>
                    <a:lvl5pPr marL="18288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defRPr/>
                    </a:pPr>
                    <a:r>
                      <a:rPr lang="en-GB" sz="5000" dirty="0">
                        <a:latin typeface="Arial" pitchFamily="34" charset="0"/>
                        <a:cs typeface="Arial" pitchFamily="34" charset="0"/>
                      </a:rPr>
                      <a:t>TSLPR</a:t>
                    </a:r>
                    <a:r>
                      <a:rPr lang="en-GB" sz="5000" baseline="30000" dirty="0">
                        <a:latin typeface="Arial" pitchFamily="34" charset="0"/>
                        <a:cs typeface="Arial" pitchFamily="34" charset="0"/>
                      </a:rPr>
                      <a:t>-/-</a:t>
                    </a:r>
                  </a:p>
                </p:txBody>
              </p:sp>
              <p:sp>
                <p:nvSpPr>
                  <p:cNvPr id="10" name="TextBox 240"/>
                  <p:cNvSpPr txBox="1"/>
                  <p:nvPr/>
                </p:nvSpPr>
                <p:spPr bwMode="auto">
                  <a:xfrm rot="18835675">
                    <a:off x="21656998" y="12782629"/>
                    <a:ext cx="2869696" cy="861774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>
                    <a:defPPr>
                      <a:defRPr lang="en-US"/>
                    </a:defPPr>
                    <a:lvl1pPr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1pPr>
                    <a:lvl2pPr marL="4572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2pPr>
                    <a:lvl3pPr marL="9144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3pPr>
                    <a:lvl4pPr marL="13716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4pPr>
                    <a:lvl5pPr marL="18288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defRPr/>
                    </a:pPr>
                    <a:r>
                      <a:rPr lang="en-GB" sz="5000" dirty="0">
                        <a:latin typeface="Arial" pitchFamily="34" charset="0"/>
                        <a:cs typeface="Arial" pitchFamily="34" charset="0"/>
                      </a:rPr>
                      <a:t>TSLPR</a:t>
                    </a:r>
                    <a:r>
                      <a:rPr lang="en-GB" sz="5000" baseline="30000" dirty="0">
                        <a:latin typeface="Arial" pitchFamily="34" charset="0"/>
                        <a:cs typeface="Arial" pitchFamily="34" charset="0"/>
                      </a:rPr>
                      <a:t>+/+</a:t>
                    </a:r>
                  </a:p>
                </p:txBody>
              </p:sp>
              <p:sp>
                <p:nvSpPr>
                  <p:cNvPr id="11" name="TextBox 240"/>
                  <p:cNvSpPr txBox="1"/>
                  <p:nvPr/>
                </p:nvSpPr>
                <p:spPr bwMode="auto">
                  <a:xfrm rot="18835675">
                    <a:off x="18487523" y="12748374"/>
                    <a:ext cx="2869696" cy="861774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>
                    <a:defPPr>
                      <a:defRPr lang="en-US"/>
                    </a:defPPr>
                    <a:lvl1pPr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1pPr>
                    <a:lvl2pPr marL="4572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2pPr>
                    <a:lvl3pPr marL="9144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3pPr>
                    <a:lvl4pPr marL="13716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4pPr>
                    <a:lvl5pPr marL="1828800" algn="l" rtl="0" fontAlgn="base">
                      <a:spcBef>
                        <a:spcPct val="0"/>
                      </a:spcBef>
                      <a:spcAft>
                        <a:spcPct val="0"/>
                      </a:spcAft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kern="1200">
                        <a:solidFill>
                          <a:schemeClr val="tx1"/>
                        </a:solidFill>
                        <a:latin typeface="Arial" charset="0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defRPr/>
                    </a:pPr>
                    <a:r>
                      <a:rPr lang="en-GB" sz="5000" dirty="0">
                        <a:latin typeface="Arial" pitchFamily="34" charset="0"/>
                        <a:cs typeface="Arial" pitchFamily="34" charset="0"/>
                      </a:rPr>
                      <a:t>TSLPR</a:t>
                    </a:r>
                    <a:r>
                      <a:rPr lang="en-GB" sz="5000" baseline="30000" dirty="0">
                        <a:latin typeface="Arial" pitchFamily="34" charset="0"/>
                        <a:cs typeface="Arial" pitchFamily="34" charset="0"/>
                      </a:rPr>
                      <a:t>+/+</a:t>
                    </a:r>
                  </a:p>
                </p:txBody>
              </p:sp>
            </p:grpSp>
            <p:sp>
              <p:nvSpPr>
                <p:cNvPr id="13" name="TextBox 240"/>
                <p:cNvSpPr txBox="1"/>
                <p:nvPr/>
              </p:nvSpPr>
              <p:spPr bwMode="auto">
                <a:xfrm>
                  <a:off x="24654198" y="14725512"/>
                  <a:ext cx="2794355" cy="86177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1pPr>
                  <a:lvl2pPr marL="4572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2pPr>
                  <a:lvl3pPr marL="9144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3pPr>
                  <a:lvl4pPr marL="13716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4pPr>
                  <a:lvl5pPr marL="18288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9pPr>
                </a:lstStyle>
                <a:p>
                  <a:pPr>
                    <a:defRPr/>
                  </a:pPr>
                  <a:r>
                    <a:rPr lang="en-GB" sz="5000" dirty="0">
                      <a:latin typeface="Arial" pitchFamily="34" charset="0"/>
                      <a:cs typeface="Arial" pitchFamily="34" charset="0"/>
                    </a:rPr>
                    <a:t>pro-IL-1</a:t>
                  </a:r>
                  <a:r>
                    <a:rPr lang="el-GR" sz="5000">
                      <a:latin typeface="Arial" pitchFamily="34" charset="0"/>
                      <a:cs typeface="Arial" pitchFamily="34" charset="0"/>
                    </a:rPr>
                    <a:t>β</a:t>
                  </a:r>
                  <a:endParaRPr lang="en-GB" sz="5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" name="TextBox 240"/>
                <p:cNvSpPr txBox="1"/>
                <p:nvPr/>
              </p:nvSpPr>
              <p:spPr bwMode="auto">
                <a:xfrm>
                  <a:off x="24654198" y="17450706"/>
                  <a:ext cx="2119491" cy="86177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1pPr>
                  <a:lvl2pPr marL="4572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2pPr>
                  <a:lvl3pPr marL="9144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3pPr>
                  <a:lvl4pPr marL="13716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4pPr>
                  <a:lvl5pPr marL="18288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9pPr>
                </a:lstStyle>
                <a:p>
                  <a:pPr>
                    <a:defRPr/>
                  </a:pPr>
                  <a:r>
                    <a:rPr lang="el-GR" sz="5000">
                      <a:latin typeface="Arial" pitchFamily="34" charset="0"/>
                      <a:cs typeface="Arial" pitchFamily="34" charset="0"/>
                    </a:rPr>
                    <a:t>β</a:t>
                  </a:r>
                  <a:r>
                    <a:rPr lang="en-GB" sz="5000" dirty="0">
                      <a:latin typeface="Arial" pitchFamily="34" charset="0"/>
                      <a:cs typeface="Arial" pitchFamily="34" charset="0"/>
                    </a:rPr>
                    <a:t>-actin</a:t>
                  </a:r>
                </a:p>
              </p:txBody>
            </p:sp>
            <p:sp>
              <p:nvSpPr>
                <p:cNvPr id="15" name="TextBox 240"/>
                <p:cNvSpPr txBox="1"/>
                <p:nvPr/>
              </p:nvSpPr>
              <p:spPr bwMode="auto">
                <a:xfrm>
                  <a:off x="24654198" y="16047083"/>
                  <a:ext cx="2156360" cy="86177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1pPr>
                  <a:lvl2pPr marL="4572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2pPr>
                  <a:lvl3pPr marL="9144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3pPr>
                  <a:lvl4pPr marL="13716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4pPr>
                  <a:lvl5pPr marL="18288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9pPr>
                </a:lstStyle>
                <a:p>
                  <a:pPr>
                    <a:defRPr/>
                  </a:pPr>
                  <a:r>
                    <a:rPr lang="en-GB" sz="5000" dirty="0">
                      <a:latin typeface="Arial" pitchFamily="34" charset="0"/>
                      <a:cs typeface="Arial" pitchFamily="34" charset="0"/>
                    </a:rPr>
                    <a:t>HIF-1</a:t>
                  </a:r>
                  <a:r>
                    <a:rPr lang="el-GR" sz="5000">
                      <a:latin typeface="Arial" pitchFamily="34" charset="0"/>
                      <a:cs typeface="Arial" pitchFamily="34" charset="0"/>
                    </a:rPr>
                    <a:t>α</a:t>
                  </a:r>
                  <a:endParaRPr lang="en-GB" sz="5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" name="Right Brace 15"/>
                <p:cNvSpPr/>
                <p:nvPr/>
              </p:nvSpPr>
              <p:spPr bwMode="auto">
                <a:xfrm rot="5400000">
                  <a:off x="19680259" y="17541169"/>
                  <a:ext cx="700810" cy="2828107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GB" dirty="0"/>
                </a:p>
              </p:txBody>
            </p:sp>
            <p:sp>
              <p:nvSpPr>
                <p:cNvPr id="17" name="TextBox 240"/>
                <p:cNvSpPr txBox="1"/>
                <p:nvPr/>
              </p:nvSpPr>
              <p:spPr bwMode="auto">
                <a:xfrm>
                  <a:off x="19403729" y="19305626"/>
                  <a:ext cx="1253869" cy="86177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1pPr>
                  <a:lvl2pPr marL="4572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2pPr>
                  <a:lvl3pPr marL="9144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3pPr>
                  <a:lvl4pPr marL="13716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4pPr>
                  <a:lvl5pPr marL="18288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9pPr>
                </a:lstStyle>
                <a:p>
                  <a:pPr>
                    <a:defRPr/>
                  </a:pPr>
                  <a:r>
                    <a:rPr lang="en-GB" sz="5000" dirty="0">
                      <a:latin typeface="Arial" pitchFamily="34" charset="0"/>
                      <a:cs typeface="Arial" pitchFamily="34" charset="0"/>
                    </a:rPr>
                    <a:t>U/S</a:t>
                  </a:r>
                </a:p>
              </p:txBody>
            </p:sp>
            <p:sp>
              <p:nvSpPr>
                <p:cNvPr id="18" name="Right Brace 17"/>
                <p:cNvSpPr/>
                <p:nvPr/>
              </p:nvSpPr>
              <p:spPr bwMode="auto">
                <a:xfrm rot="5400000">
                  <a:off x="22633148" y="17541170"/>
                  <a:ext cx="700809" cy="2828107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anchor="ctr"/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GB" dirty="0"/>
                </a:p>
              </p:txBody>
            </p:sp>
            <p:sp>
              <p:nvSpPr>
                <p:cNvPr id="19" name="TextBox 240"/>
                <p:cNvSpPr txBox="1"/>
                <p:nvPr/>
              </p:nvSpPr>
              <p:spPr bwMode="auto">
                <a:xfrm>
                  <a:off x="21542240" y="19305626"/>
                  <a:ext cx="3140603" cy="86177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1pPr>
                  <a:lvl2pPr marL="4572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2pPr>
                  <a:lvl3pPr marL="9144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3pPr>
                  <a:lvl4pPr marL="13716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4pPr>
                  <a:lvl5pPr marL="1828800" algn="l" rtl="0" fontAlgn="base">
                    <a:spcBef>
                      <a:spcPct val="0"/>
                    </a:spcBef>
                    <a:spcAft>
                      <a:spcPct val="0"/>
                    </a:spcAft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kern="1200">
                      <a:solidFill>
                        <a:schemeClr val="tx1"/>
                      </a:solidFill>
                      <a:latin typeface="Arial" charset="0"/>
                      <a:ea typeface="+mn-ea"/>
                      <a:cs typeface="+mn-cs"/>
                    </a:defRPr>
                  </a:lvl9pPr>
                </a:lstStyle>
                <a:p>
                  <a:pPr>
                    <a:defRPr/>
                  </a:pPr>
                  <a:r>
                    <a:rPr lang="en-GB" sz="5000" dirty="0">
                      <a:latin typeface="Arial" pitchFamily="34" charset="0"/>
                      <a:cs typeface="Arial" pitchFamily="34" charset="0"/>
                    </a:rPr>
                    <a:t>SC glucan</a:t>
                  </a:r>
                </a:p>
              </p:txBody>
            </p:sp>
          </p:grpSp>
          <p:sp>
            <p:nvSpPr>
              <p:cNvPr id="21" name="TextBox 2"/>
              <p:cNvSpPr txBox="1">
                <a:spLocks noChangeArrowheads="1"/>
              </p:cNvSpPr>
              <p:nvPr/>
            </p:nvSpPr>
            <p:spPr bwMode="auto">
              <a:xfrm>
                <a:off x="6449846" y="8987201"/>
                <a:ext cx="832279" cy="11695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7000" b="1" dirty="0" smtClean="0">
                    <a:latin typeface="Arial" charset="0"/>
                  </a:rPr>
                  <a:t>B</a:t>
                </a:r>
                <a:endParaRPr lang="en-GB" altLang="en-US" sz="7000" b="1" dirty="0">
                  <a:latin typeface="Arial" charset="0"/>
                </a:endParaRPr>
              </a:p>
            </p:txBody>
          </p:sp>
        </p:grpSp>
        <p:pic>
          <p:nvPicPr>
            <p:cNvPr id="1026" name="Picture 2" descr="V:\Matt adn TSLP project\aTSLP Paper\Figure 2\Lactate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32202" y="6734634"/>
              <a:ext cx="5760640" cy="90511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TextBox 2"/>
            <p:cNvSpPr txBox="1">
              <a:spLocks noChangeArrowheads="1"/>
            </p:cNvSpPr>
            <p:nvPr/>
          </p:nvSpPr>
          <p:spPr bwMode="auto">
            <a:xfrm>
              <a:off x="6264996" y="6945830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A</a:t>
              </a:r>
              <a:endParaRPr lang="en-GB" altLang="en-US" sz="7000" b="1" dirty="0">
                <a:latin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748154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3181890" y="9073233"/>
            <a:ext cx="15265696" cy="10108350"/>
            <a:chOff x="13609812" y="7632707"/>
            <a:chExt cx="15265696" cy="10108350"/>
          </a:xfrm>
        </p:grpSpPr>
        <p:pic>
          <p:nvPicPr>
            <p:cNvPr id="5" name="Picture 2" descr="V:\Matt adn TSLP project\aTSLP Paper\Supplemental Figure 4\IL-1b_expression_graph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609812" y="7632707"/>
              <a:ext cx="7416824" cy="100813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3" descr="V:\Matt adn TSLP project\aTSLP Paper\Supplemental Figure 4\HIF1a_expression_graph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458684" y="7659685"/>
              <a:ext cx="7416824" cy="100813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2"/>
            <p:cNvSpPr txBox="1">
              <a:spLocks noChangeArrowheads="1"/>
            </p:cNvSpPr>
            <p:nvPr/>
          </p:nvSpPr>
          <p:spPr bwMode="auto">
            <a:xfrm>
              <a:off x="22954164" y="7993113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B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8" name="TextBox 2"/>
            <p:cNvSpPr txBox="1">
              <a:spLocks noChangeArrowheads="1"/>
            </p:cNvSpPr>
            <p:nvPr/>
          </p:nvSpPr>
          <p:spPr bwMode="auto">
            <a:xfrm>
              <a:off x="15121980" y="7993113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A</a:t>
              </a:r>
              <a:endParaRPr lang="en-GB" altLang="en-US" sz="7000" b="1" dirty="0">
                <a:latin typeface="Arial" charset="0"/>
              </a:endParaRPr>
            </a:p>
          </p:txBody>
        </p:sp>
      </p:grpSp>
      <p:sp>
        <p:nvSpPr>
          <p:cNvPr id="10" name="Rectangle 9"/>
          <p:cNvSpPr/>
          <p:nvPr/>
        </p:nvSpPr>
        <p:spPr>
          <a:xfrm>
            <a:off x="3880884" y="317648"/>
            <a:ext cx="35507585" cy="1000266"/>
          </a:xfrm>
          <a:prstGeom prst="rect">
            <a:avLst/>
          </a:prstGeom>
        </p:spPr>
        <p:txBody>
          <a:bodyPr wrap="none" lIns="91430" tIns="45716" rIns="91430" bIns="45716">
            <a:spAutoFit/>
          </a:bodyPr>
          <a:lstStyle/>
          <a:p>
            <a:pPr algn="ctr">
              <a:spcBef>
                <a:spcPct val="0"/>
              </a:spcBef>
            </a:pPr>
            <a:r>
              <a:rPr lang="en-GB" sz="5900" b="1" dirty="0"/>
              <a:t>Supplemental Figure 4 HIF-1</a:t>
            </a:r>
            <a:r>
              <a:rPr lang="el-GR" sz="5900" b="1" dirty="0"/>
              <a:t>α</a:t>
            </a:r>
            <a:r>
              <a:rPr lang="en-GB" sz="5900" b="1" dirty="0"/>
              <a:t> mRNA expression is unaffected by TSLPR neutralization in dectin-1-stimulated mDC</a:t>
            </a:r>
            <a:endParaRPr lang="en-GB" sz="5900" dirty="0"/>
          </a:p>
        </p:txBody>
      </p:sp>
      <p:sp>
        <p:nvSpPr>
          <p:cNvPr id="11" name="Rectangle 10"/>
          <p:cNvSpPr>
            <a:spLocks noChangeArrowheads="1"/>
          </p:cNvSpPr>
          <p:nvPr/>
        </p:nvSpPr>
        <p:spPr bwMode="auto">
          <a:xfrm>
            <a:off x="752356" y="23474833"/>
            <a:ext cx="41764640" cy="34163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algn="just"/>
            <a:r>
              <a:rPr lang="en-GB" altLang="en-US" sz="5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F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is unaffected by TSLPR neutralization in dectin-1-stimulated mDC.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B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mDC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were stimulated with SC glucan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either anti-TSLP, anti-TSLPR or IgG isotype control antibodies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four hours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=5 independent donors, presented as pooled data). Pro-IL-1</a:t>
            </a:r>
            <a:r>
              <a:rPr lang="el-GR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HIF-1</a:t>
            </a:r>
            <a:r>
              <a:rPr lang="el-GR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RNA expression was measured relative to HPRT expression by quantitative real-time PCR.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mulative data displayed as mean </a:t>
            </a:r>
            <a:r>
              <a:rPr lang="en-GB" sz="54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. Statistical analysis calculated using one-way ANOVA with Bonferroni post-tests (ns = not significant, * p=0.05). </a:t>
            </a:r>
            <a:endParaRPr lang="en-GB" sz="54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80172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693971" y="317648"/>
            <a:ext cx="35881406" cy="1908207"/>
          </a:xfrm>
          <a:prstGeom prst="rect">
            <a:avLst/>
          </a:prstGeom>
        </p:spPr>
        <p:txBody>
          <a:bodyPr wrap="none" lIns="91430" tIns="45716" rIns="91430" bIns="45716">
            <a:spAutoFit/>
          </a:bodyPr>
          <a:lstStyle/>
          <a:p>
            <a:pPr algn="ctr">
              <a:spcBef>
                <a:spcPct val="0"/>
              </a:spcBef>
            </a:pPr>
            <a:r>
              <a:rPr lang="en-GB" sz="5900" b="1" dirty="0"/>
              <a:t>Supplemental Figure 5 – mDC derived from CGD donors do not produce ROS in response to SC glucan stimulation</a:t>
            </a:r>
          </a:p>
          <a:p>
            <a:pPr algn="ctr">
              <a:spcBef>
                <a:spcPct val="0"/>
              </a:spcBef>
            </a:pPr>
            <a:r>
              <a:rPr lang="en-GB" sz="5900" b="1" dirty="0"/>
              <a:t> </a:t>
            </a:r>
            <a:endParaRPr lang="en-GB" sz="5900" dirty="0"/>
          </a:p>
        </p:txBody>
      </p:sp>
      <p:sp>
        <p:nvSpPr>
          <p:cNvPr id="37" name="Rectangle 36"/>
          <p:cNvSpPr>
            <a:spLocks noChangeArrowheads="1"/>
          </p:cNvSpPr>
          <p:nvPr/>
        </p:nvSpPr>
        <p:spPr bwMode="auto">
          <a:xfrm>
            <a:off x="752356" y="23474833"/>
            <a:ext cx="41764640" cy="25853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algn="just"/>
            <a:r>
              <a:rPr lang="en-GB" altLang="en-US" sz="5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5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DC derived from CGD donors do not produce ROS in response to SC glucan stimulation.</a:t>
            </a:r>
            <a:r>
              <a:rPr lang="en-GB" altLang="en-US" sz="5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mDC derived from healthy donors (HD) or CGD patients were stimulated with SC glucan, and ROS was measured by fluorescence of the luminol-based chemiluminescent probe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012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ver 30 minutes using a luminometer. A representative time course experiment is shown.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xmlns="" id="{D70CD717-0845-42B1-BFD8-6A0F1C4DD4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106835"/>
              </p:ext>
            </p:extLst>
          </p:nvPr>
        </p:nvGraphicFramePr>
        <p:xfrm>
          <a:off x="6663374" y="7777089"/>
          <a:ext cx="29878651" cy="136217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" name="Prism 8" r:id="rId3" imgW="6695510" imgH="3052115" progId="Prism8.Document">
                  <p:embed/>
                </p:oleObj>
              </mc:Choice>
              <mc:Fallback>
                <p:oleObj name="Prism 8" r:id="rId3" imgW="6695510" imgH="3052115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xmlns="" id="{D70CD717-0845-42B1-BFD8-6A0F1C4DD4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63374" y="7777089"/>
                        <a:ext cx="29878651" cy="136217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506522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318580" y="317648"/>
            <a:ext cx="36632188" cy="1000266"/>
          </a:xfrm>
          <a:prstGeom prst="rect">
            <a:avLst/>
          </a:prstGeom>
        </p:spPr>
        <p:txBody>
          <a:bodyPr wrap="none" lIns="91430" tIns="45716" rIns="91430" bIns="45716">
            <a:spAutoFit/>
          </a:bodyPr>
          <a:lstStyle/>
          <a:p>
            <a:pPr algn="ctr">
              <a:spcBef>
                <a:spcPct val="0"/>
              </a:spcBef>
            </a:pPr>
            <a:r>
              <a:rPr lang="en-GB" sz="5900" b="1" dirty="0"/>
              <a:t>Supplemental Figure 6 – Syk phosphorylation is dectin-1 dependent and pro-IL-1</a:t>
            </a:r>
            <a:r>
              <a:rPr lang="el-GR" sz="5900" b="1" dirty="0"/>
              <a:t>β</a:t>
            </a:r>
            <a:r>
              <a:rPr lang="en-GB" sz="5900" b="1" dirty="0"/>
              <a:t> and HIF-1</a:t>
            </a:r>
            <a:r>
              <a:rPr lang="el-GR" sz="5900" b="1" dirty="0"/>
              <a:t>α</a:t>
            </a:r>
            <a:r>
              <a:rPr lang="en-GB" sz="5900" b="1" dirty="0"/>
              <a:t> requires Syk activation </a:t>
            </a:r>
            <a:endParaRPr lang="en-GB" sz="5900" dirty="0"/>
          </a:p>
        </p:txBody>
      </p:sp>
      <p:grpSp>
        <p:nvGrpSpPr>
          <p:cNvPr id="19" name="Group 18"/>
          <p:cNvGrpSpPr/>
          <p:nvPr/>
        </p:nvGrpSpPr>
        <p:grpSpPr>
          <a:xfrm>
            <a:off x="11096534" y="9865321"/>
            <a:ext cx="21076231" cy="9759811"/>
            <a:chOff x="5671700" y="7278337"/>
            <a:chExt cx="21076231" cy="9759811"/>
          </a:xfrm>
        </p:grpSpPr>
        <p:grpSp>
          <p:nvGrpSpPr>
            <p:cNvPr id="2" name="Group 1"/>
            <p:cNvGrpSpPr/>
            <p:nvPr/>
          </p:nvGrpSpPr>
          <p:grpSpPr>
            <a:xfrm>
              <a:off x="16814556" y="7278337"/>
              <a:ext cx="9933375" cy="9759811"/>
              <a:chOff x="17639952" y="8690016"/>
              <a:chExt cx="9933375" cy="9759811"/>
            </a:xfrm>
          </p:grpSpPr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39952" y="15305226"/>
                <a:ext cx="7989395" cy="143827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3075" name="Picture 3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58510" y="13537729"/>
                <a:ext cx="7970837" cy="143827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7" name="TextBox 240"/>
              <p:cNvSpPr txBox="1"/>
              <p:nvPr/>
            </p:nvSpPr>
            <p:spPr bwMode="auto">
              <a:xfrm rot="18835675">
                <a:off x="23019528" y="11697048"/>
                <a:ext cx="3046027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l-GR" sz="500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-dectin-1</a:t>
                </a:r>
              </a:p>
            </p:txBody>
          </p:sp>
          <p:sp>
            <p:nvSpPr>
              <p:cNvPr id="8" name="TextBox 240"/>
              <p:cNvSpPr txBox="1"/>
              <p:nvPr/>
            </p:nvSpPr>
            <p:spPr bwMode="auto">
              <a:xfrm rot="18835675">
                <a:off x="24043058" y="10903443"/>
                <a:ext cx="5288627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l-GR" sz="5000" dirty="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-dectin-1 Isotype</a:t>
                </a:r>
              </a:p>
            </p:txBody>
          </p:sp>
          <p:sp>
            <p:nvSpPr>
              <p:cNvPr id="9" name="TextBox 240"/>
              <p:cNvSpPr txBox="1"/>
              <p:nvPr/>
            </p:nvSpPr>
            <p:spPr bwMode="auto">
              <a:xfrm rot="18835675">
                <a:off x="22021094" y="12382363"/>
                <a:ext cx="1181734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Ctrl</a:t>
                </a:r>
              </a:p>
            </p:txBody>
          </p:sp>
          <p:sp>
            <p:nvSpPr>
              <p:cNvPr id="10" name="TextBox 240"/>
              <p:cNvSpPr txBox="1"/>
              <p:nvPr/>
            </p:nvSpPr>
            <p:spPr bwMode="auto">
              <a:xfrm rot="18835675">
                <a:off x="18729867" y="11697049"/>
                <a:ext cx="3046027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l-GR" sz="500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-dectin-1</a:t>
                </a:r>
              </a:p>
            </p:txBody>
          </p:sp>
          <p:sp>
            <p:nvSpPr>
              <p:cNvPr id="11" name="TextBox 240"/>
              <p:cNvSpPr txBox="1"/>
              <p:nvPr/>
            </p:nvSpPr>
            <p:spPr bwMode="auto">
              <a:xfrm rot="18835675">
                <a:off x="19753397" y="10903444"/>
                <a:ext cx="5288627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l-GR" sz="5000" dirty="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-dectin-1 Isotype</a:t>
                </a:r>
              </a:p>
            </p:txBody>
          </p:sp>
          <p:sp>
            <p:nvSpPr>
              <p:cNvPr id="12" name="TextBox 240"/>
              <p:cNvSpPr txBox="1"/>
              <p:nvPr/>
            </p:nvSpPr>
            <p:spPr bwMode="auto">
              <a:xfrm rot="18835675">
                <a:off x="17731433" y="12382364"/>
                <a:ext cx="1181734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Ctrl</a:t>
                </a:r>
              </a:p>
            </p:txBody>
          </p:sp>
          <p:sp>
            <p:nvSpPr>
              <p:cNvPr id="13" name="TextBox 240"/>
              <p:cNvSpPr txBox="1"/>
              <p:nvPr/>
            </p:nvSpPr>
            <p:spPr bwMode="auto">
              <a:xfrm>
                <a:off x="25750393" y="15593476"/>
                <a:ext cx="1253869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Syk</a:t>
                </a:r>
              </a:p>
            </p:txBody>
          </p:sp>
          <p:sp>
            <p:nvSpPr>
              <p:cNvPr id="14" name="TextBox 240"/>
              <p:cNvSpPr txBox="1"/>
              <p:nvPr/>
            </p:nvSpPr>
            <p:spPr bwMode="auto">
              <a:xfrm>
                <a:off x="25750392" y="13825979"/>
                <a:ext cx="1822935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p-Syk</a:t>
                </a:r>
              </a:p>
            </p:txBody>
          </p:sp>
          <p:sp>
            <p:nvSpPr>
              <p:cNvPr id="15" name="TextBox 240"/>
              <p:cNvSpPr txBox="1"/>
              <p:nvPr/>
            </p:nvSpPr>
            <p:spPr bwMode="auto">
              <a:xfrm>
                <a:off x="21989834" y="17588053"/>
                <a:ext cx="3140603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SC glucan</a:t>
                </a:r>
              </a:p>
            </p:txBody>
          </p:sp>
          <p:sp>
            <p:nvSpPr>
              <p:cNvPr id="16" name="Right Brace 15"/>
              <p:cNvSpPr/>
              <p:nvPr/>
            </p:nvSpPr>
            <p:spPr bwMode="auto">
              <a:xfrm rot="5400000">
                <a:off x="23200096" y="15644482"/>
                <a:ext cx="720080" cy="3429944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endParaRPr lang="en-GB" dirty="0"/>
              </a:p>
            </p:txBody>
          </p:sp>
          <p:sp>
            <p:nvSpPr>
              <p:cNvPr id="17" name="Right Brace 16"/>
              <p:cNvSpPr/>
              <p:nvPr/>
            </p:nvSpPr>
            <p:spPr bwMode="auto">
              <a:xfrm rot="5400000">
                <a:off x="19358778" y="15644482"/>
                <a:ext cx="720080" cy="3429944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endParaRPr lang="en-GB" dirty="0"/>
              </a:p>
            </p:txBody>
          </p:sp>
          <p:sp>
            <p:nvSpPr>
              <p:cNvPr id="18" name="TextBox 240"/>
              <p:cNvSpPr txBox="1"/>
              <p:nvPr/>
            </p:nvSpPr>
            <p:spPr bwMode="auto">
              <a:xfrm>
                <a:off x="19091883" y="17588053"/>
                <a:ext cx="1253869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U/S</a:t>
                </a:r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6553028" y="9061601"/>
              <a:ext cx="7983344" cy="7710020"/>
              <a:chOff x="19045237" y="10632348"/>
              <a:chExt cx="7983344" cy="7710020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045238" y="15606713"/>
                <a:ext cx="5114925" cy="119062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045237" y="12706709"/>
                <a:ext cx="5114926" cy="118278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045237" y="14135674"/>
                <a:ext cx="5114925" cy="119062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22" name="TextBox 240"/>
              <p:cNvSpPr txBox="1"/>
              <p:nvPr/>
            </p:nvSpPr>
            <p:spPr bwMode="auto">
              <a:xfrm>
                <a:off x="24162091" y="12867216"/>
                <a:ext cx="2866490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Pro-IL-1</a:t>
                </a:r>
                <a:r>
                  <a:rPr lang="el-GR" sz="5000">
                    <a:latin typeface="Arial" pitchFamily="34" charset="0"/>
                    <a:cs typeface="Arial" pitchFamily="34" charset="0"/>
                  </a:rPr>
                  <a:t>β</a:t>
                </a:r>
                <a:endParaRPr lang="en-GB" sz="5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40"/>
              <p:cNvSpPr txBox="1"/>
              <p:nvPr/>
            </p:nvSpPr>
            <p:spPr bwMode="auto">
              <a:xfrm>
                <a:off x="24160162" y="14300099"/>
                <a:ext cx="2156360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HIF-1</a:t>
                </a:r>
                <a:r>
                  <a:rPr lang="el-GR" sz="5000">
                    <a:latin typeface="Arial" pitchFamily="34" charset="0"/>
                    <a:cs typeface="Arial" pitchFamily="34" charset="0"/>
                  </a:rPr>
                  <a:t>α</a:t>
                </a:r>
                <a:endParaRPr lang="en-GB" sz="5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TextBox 240"/>
              <p:cNvSpPr txBox="1"/>
              <p:nvPr/>
            </p:nvSpPr>
            <p:spPr bwMode="auto">
              <a:xfrm>
                <a:off x="24160162" y="15771138"/>
                <a:ext cx="2119491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l-GR" sz="500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-actin</a:t>
                </a:r>
              </a:p>
            </p:txBody>
          </p:sp>
          <p:sp>
            <p:nvSpPr>
              <p:cNvPr id="25" name="TextBox 240"/>
              <p:cNvSpPr txBox="1"/>
              <p:nvPr/>
            </p:nvSpPr>
            <p:spPr bwMode="auto">
              <a:xfrm rot="18835675">
                <a:off x="22953164" y="11477233"/>
                <a:ext cx="1609736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Syk-i</a:t>
                </a:r>
              </a:p>
            </p:txBody>
          </p:sp>
          <p:sp>
            <p:nvSpPr>
              <p:cNvPr id="26" name="TextBox 240"/>
              <p:cNvSpPr txBox="1"/>
              <p:nvPr/>
            </p:nvSpPr>
            <p:spPr bwMode="auto">
              <a:xfrm rot="18835675">
                <a:off x="21541544" y="11326868"/>
                <a:ext cx="2250809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Vehicle</a:t>
                </a:r>
              </a:p>
            </p:txBody>
          </p:sp>
          <p:sp>
            <p:nvSpPr>
              <p:cNvPr id="27" name="TextBox 240"/>
              <p:cNvSpPr txBox="1"/>
              <p:nvPr/>
            </p:nvSpPr>
            <p:spPr bwMode="auto">
              <a:xfrm rot="18835675">
                <a:off x="20409918" y="11477231"/>
                <a:ext cx="1609736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Syk-i</a:t>
                </a:r>
              </a:p>
            </p:txBody>
          </p:sp>
          <p:sp>
            <p:nvSpPr>
              <p:cNvPr id="28" name="TextBox 240"/>
              <p:cNvSpPr txBox="1"/>
              <p:nvPr/>
            </p:nvSpPr>
            <p:spPr bwMode="auto">
              <a:xfrm rot="18835675">
                <a:off x="18998298" y="11326866"/>
                <a:ext cx="2250809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Vehicle</a:t>
                </a:r>
              </a:p>
            </p:txBody>
          </p:sp>
          <p:sp>
            <p:nvSpPr>
              <p:cNvPr id="29" name="TextBox 240"/>
              <p:cNvSpPr txBox="1"/>
              <p:nvPr/>
            </p:nvSpPr>
            <p:spPr bwMode="auto">
              <a:xfrm>
                <a:off x="21457815" y="17480594"/>
                <a:ext cx="3140603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SC glucan</a:t>
                </a:r>
              </a:p>
            </p:txBody>
          </p:sp>
          <p:sp>
            <p:nvSpPr>
              <p:cNvPr id="30" name="Right Brace 29"/>
              <p:cNvSpPr/>
              <p:nvPr/>
            </p:nvSpPr>
            <p:spPr bwMode="auto">
              <a:xfrm rot="5400000">
                <a:off x="22585190" y="16128573"/>
                <a:ext cx="613853" cy="2223479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endParaRPr lang="en-GB" dirty="0"/>
              </a:p>
            </p:txBody>
          </p:sp>
          <p:sp>
            <p:nvSpPr>
              <p:cNvPr id="32" name="Right Brace 31"/>
              <p:cNvSpPr/>
              <p:nvPr/>
            </p:nvSpPr>
            <p:spPr bwMode="auto">
              <a:xfrm rot="5400000">
                <a:off x="20039149" y="16128572"/>
                <a:ext cx="613853" cy="2223479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endParaRPr lang="en-GB" dirty="0"/>
              </a:p>
            </p:txBody>
          </p:sp>
          <p:sp>
            <p:nvSpPr>
              <p:cNvPr id="33" name="TextBox 240"/>
              <p:cNvSpPr txBox="1"/>
              <p:nvPr/>
            </p:nvSpPr>
            <p:spPr bwMode="auto">
              <a:xfrm>
                <a:off x="19719141" y="17480594"/>
                <a:ext cx="1253869" cy="86177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5000" dirty="0">
                    <a:latin typeface="Arial" pitchFamily="34" charset="0"/>
                    <a:cs typeface="Arial" pitchFamily="34" charset="0"/>
                  </a:rPr>
                  <a:t>U/S</a:t>
                </a:r>
              </a:p>
            </p:txBody>
          </p:sp>
        </p:grpSp>
        <p:sp>
          <p:nvSpPr>
            <p:cNvPr id="36" name="TextBox 2"/>
            <p:cNvSpPr txBox="1">
              <a:spLocks noChangeArrowheads="1"/>
            </p:cNvSpPr>
            <p:nvPr/>
          </p:nvSpPr>
          <p:spPr bwMode="auto">
            <a:xfrm>
              <a:off x="5671700" y="9752595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A</a:t>
              </a:r>
              <a:endParaRPr lang="en-GB" altLang="en-US" sz="7000" b="1" dirty="0">
                <a:latin typeface="Arial" charset="0"/>
              </a:endParaRPr>
            </a:p>
          </p:txBody>
        </p:sp>
        <p:sp>
          <p:nvSpPr>
            <p:cNvPr id="38" name="TextBox 2"/>
            <p:cNvSpPr txBox="1">
              <a:spLocks noChangeArrowheads="1"/>
            </p:cNvSpPr>
            <p:nvPr/>
          </p:nvSpPr>
          <p:spPr bwMode="auto">
            <a:xfrm>
              <a:off x="15983698" y="9966411"/>
              <a:ext cx="832279" cy="11695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7000" b="1" dirty="0" smtClean="0">
                  <a:latin typeface="Arial" charset="0"/>
                </a:rPr>
                <a:t>B</a:t>
              </a:r>
              <a:endParaRPr lang="en-GB" altLang="en-US" sz="7000" b="1" dirty="0">
                <a:latin typeface="Arial" charset="0"/>
              </a:endParaRPr>
            </a:p>
          </p:txBody>
        </p:sp>
      </p:grpSp>
      <p:sp>
        <p:nvSpPr>
          <p:cNvPr id="37" name="Rectangle 36"/>
          <p:cNvSpPr>
            <a:spLocks noChangeArrowheads="1"/>
          </p:cNvSpPr>
          <p:nvPr/>
        </p:nvSpPr>
        <p:spPr bwMode="auto">
          <a:xfrm>
            <a:off x="752356" y="23474833"/>
            <a:ext cx="41764640" cy="34163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algn="just"/>
            <a:r>
              <a:rPr lang="en-GB" altLang="en-US" sz="5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6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k phosphorylation is dectin-1 dependent and pro-IL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HIF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quires Syk activation.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mDC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were stimulated with SC glucan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GB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urs with a </a:t>
            </a:r>
            <a:r>
              <a:rPr lang="en-GB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k inhibitor or 0.05% DMSO vehicle control (n=1 representative donor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sented, two separate experiments performed). 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altLang="en-US" sz="5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altLang="en-US" sz="5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altLang="en-US" sz="5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mDC</a:t>
            </a:r>
            <a:r>
              <a:rPr lang="en-GB" sz="5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were stimulated with SC glucan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8</a:t>
            </a:r>
            <a:r>
              <a:rPr lang="en-GB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urs with an anti-dectin-1 or IgG2a isotype control antibodies (n=1 donor presented). Pro-IL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IF-1</a:t>
            </a:r>
            <a:r>
              <a:rPr lang="el-G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yk phosphorylation were detected by immunoblot.</a:t>
            </a:r>
            <a:endParaRPr lang="en-GB" sz="5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7303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8</TotalTime>
  <Words>790</Words>
  <Application>Microsoft Office PowerPoint</Application>
  <PresentationFormat>Custom</PresentationFormat>
  <Paragraphs>59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Office Theme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C Goodall</dc:creator>
  <cp:lastModifiedBy>Praveenkumar B.</cp:lastModifiedBy>
  <cp:revision>72</cp:revision>
  <dcterms:created xsi:type="dcterms:W3CDTF">2016-01-20T13:51:20Z</dcterms:created>
  <dcterms:modified xsi:type="dcterms:W3CDTF">2019-05-02T14:03:53Z</dcterms:modified>
</cp:coreProperties>
</file>